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24.png" ContentType="image/png"/>
  <Override PartName="/ppt/media/image61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31.png" ContentType="image/png"/>
  <Override PartName="/ppt/media/image68.png" ContentType="image/png"/>
  <Override PartName="/ppt/media/image66.png" ContentType="image/png"/>
  <Override PartName="/ppt/media/image79.png" ContentType="image/png"/>
  <Override PartName="/ppt/media/image67.png" ContentType="image/png"/>
  <Override PartName="/ppt/media/image78.png" ContentType="image/png"/>
  <Override PartName="/ppt/media/image77.png" ContentType="image/png"/>
  <Override PartName="/ppt/media/image76.png" ContentType="image/png"/>
  <Override PartName="/ppt/media/image75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70.png" ContentType="image/png"/>
  <Override PartName="/ppt/media/image28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81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8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83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6DD09-6FE8-4602-8782-12821A8E2A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1DC8A-424E-435E-8A3E-3710316F89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0FCFF-67F5-4B7D-990A-1E101602F4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84B59-C5EF-47AA-8F54-B2ABEBC3B0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CAE64-8097-409B-A147-FF0697261B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9C5F7-FB97-409F-9078-4AA19A8928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CE698-D749-45C8-A2D5-2C9DEC3B63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AF23C-C78B-49F9-B05D-63A884FEA0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D0270-82C6-496F-A71F-0F03410157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6E3E0-1D3F-45B1-9DF6-7EF1F161E3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20447-9154-4A92-AF86-C9B908EC51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B5476-8791-4E00-A75C-2F804A1806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65CEBB-F32E-4283-AC8D-B638D44EB09E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37" Type="http://schemas.openxmlformats.org/officeDocument/2006/relationships/image" Target="../media/image37.png"/><Relationship Id="rId38" Type="http://schemas.openxmlformats.org/officeDocument/2006/relationships/image" Target="../media/image38.png"/><Relationship Id="rId39" Type="http://schemas.openxmlformats.org/officeDocument/2006/relationships/image" Target="../media/image39.png"/><Relationship Id="rId40" Type="http://schemas.openxmlformats.org/officeDocument/2006/relationships/image" Target="../media/image40.png"/><Relationship Id="rId41" Type="http://schemas.openxmlformats.org/officeDocument/2006/relationships/image" Target="../media/image41.png"/><Relationship Id="rId42" Type="http://schemas.openxmlformats.org/officeDocument/2006/relationships/image" Target="../media/image42.png"/><Relationship Id="rId43" Type="http://schemas.openxmlformats.org/officeDocument/2006/relationships/image" Target="../media/image43.png"/><Relationship Id="rId44" Type="http://schemas.openxmlformats.org/officeDocument/2006/relationships/image" Target="../media/image44.png"/><Relationship Id="rId45" Type="http://schemas.openxmlformats.org/officeDocument/2006/relationships/image" Target="../media/image45.png"/><Relationship Id="rId46" Type="http://schemas.openxmlformats.org/officeDocument/2006/relationships/image" Target="../media/image46.png"/><Relationship Id="rId47" Type="http://schemas.openxmlformats.org/officeDocument/2006/relationships/image" Target="../media/image47.png"/><Relationship Id="rId48" Type="http://schemas.openxmlformats.org/officeDocument/2006/relationships/image" Target="../media/image48.png"/><Relationship Id="rId49" Type="http://schemas.openxmlformats.org/officeDocument/2006/relationships/image" Target="../media/image49.png"/><Relationship Id="rId50" Type="http://schemas.openxmlformats.org/officeDocument/2006/relationships/image" Target="../media/image50.png"/><Relationship Id="rId51" Type="http://schemas.openxmlformats.org/officeDocument/2006/relationships/image" Target="../media/image51.png"/><Relationship Id="rId52" Type="http://schemas.openxmlformats.org/officeDocument/2006/relationships/image" Target="../media/image52.png"/><Relationship Id="rId53" Type="http://schemas.openxmlformats.org/officeDocument/2006/relationships/image" Target="../media/image53.png"/><Relationship Id="rId54" Type="http://schemas.openxmlformats.org/officeDocument/2006/relationships/image" Target="../media/image54.png"/><Relationship Id="rId55" Type="http://schemas.openxmlformats.org/officeDocument/2006/relationships/image" Target="../media/image55.png"/><Relationship Id="rId56" Type="http://schemas.openxmlformats.org/officeDocument/2006/relationships/image" Target="../media/image56.png"/><Relationship Id="rId57" Type="http://schemas.openxmlformats.org/officeDocument/2006/relationships/image" Target="../media/image57.png"/><Relationship Id="rId58" Type="http://schemas.openxmlformats.org/officeDocument/2006/relationships/image" Target="../media/image58.png"/><Relationship Id="rId59" Type="http://schemas.openxmlformats.org/officeDocument/2006/relationships/image" Target="../media/image59.png"/><Relationship Id="rId60" Type="http://schemas.openxmlformats.org/officeDocument/2006/relationships/image" Target="../media/image60.png"/><Relationship Id="rId61" Type="http://schemas.openxmlformats.org/officeDocument/2006/relationships/image" Target="../media/image61.png"/><Relationship Id="rId62" Type="http://schemas.openxmlformats.org/officeDocument/2006/relationships/image" Target="../media/image62.png"/><Relationship Id="rId63" Type="http://schemas.openxmlformats.org/officeDocument/2006/relationships/image" Target="../media/image63.png"/><Relationship Id="rId64" Type="http://schemas.openxmlformats.org/officeDocument/2006/relationships/image" Target="../media/image64.png"/><Relationship Id="rId65" Type="http://schemas.openxmlformats.org/officeDocument/2006/relationships/image" Target="../media/image65.png"/><Relationship Id="rId66" Type="http://schemas.openxmlformats.org/officeDocument/2006/relationships/image" Target="../media/image66.png"/><Relationship Id="rId67" Type="http://schemas.openxmlformats.org/officeDocument/2006/relationships/image" Target="../media/image67.png"/><Relationship Id="rId68" Type="http://schemas.openxmlformats.org/officeDocument/2006/relationships/image" Target="../media/image68.png"/><Relationship Id="rId69" Type="http://schemas.openxmlformats.org/officeDocument/2006/relationships/image" Target="../media/image69.png"/><Relationship Id="rId70" Type="http://schemas.openxmlformats.org/officeDocument/2006/relationships/image" Target="../media/image70.png"/><Relationship Id="rId71" Type="http://schemas.openxmlformats.org/officeDocument/2006/relationships/image" Target="../media/image71.png"/><Relationship Id="rId72" Type="http://schemas.openxmlformats.org/officeDocument/2006/relationships/image" Target="../media/image72.png"/><Relationship Id="rId73" Type="http://schemas.openxmlformats.org/officeDocument/2006/relationships/image" Target="../media/image73.png"/><Relationship Id="rId74" Type="http://schemas.openxmlformats.org/officeDocument/2006/relationships/image" Target="../media/image74.png"/><Relationship Id="rId75" Type="http://schemas.openxmlformats.org/officeDocument/2006/relationships/image" Target="../media/image75.png"/><Relationship Id="rId76" Type="http://schemas.openxmlformats.org/officeDocument/2006/relationships/image" Target="../media/image76.png"/><Relationship Id="rId77" Type="http://schemas.openxmlformats.org/officeDocument/2006/relationships/image" Target="../media/image77.png"/><Relationship Id="rId78" Type="http://schemas.openxmlformats.org/officeDocument/2006/relationships/image" Target="../media/image78.png"/><Relationship Id="rId79" Type="http://schemas.openxmlformats.org/officeDocument/2006/relationships/image" Target="../media/image79.png"/><Relationship Id="rId80" Type="http://schemas.openxmlformats.org/officeDocument/2006/relationships/image" Target="../media/image80.png"/><Relationship Id="rId81" Type="http://schemas.openxmlformats.org/officeDocument/2006/relationships/image" Target="../media/image81.png"/><Relationship Id="rId82" Type="http://schemas.openxmlformats.org/officeDocument/2006/relationships/image" Target="../media/image82.png"/><Relationship Id="rId83" Type="http://schemas.openxmlformats.org/officeDocument/2006/relationships/image" Target="../media/image83.png"/><Relationship Id="rId8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-23760" y="476280"/>
            <a:ext cx="9167400" cy="6381720"/>
            <a:chOff x="-23760" y="476280"/>
            <a:chExt cx="9167400" cy="6381720"/>
          </a:xfrm>
        </p:grpSpPr>
        <p:sp>
          <p:nvSpPr>
            <p:cNvPr id="42" name="Rectangle à coins arrondis 206"/>
            <p:cNvSpPr/>
            <p:nvPr/>
          </p:nvSpPr>
          <p:spPr>
            <a:xfrm rot="1271400">
              <a:off x="1553760" y="2414160"/>
              <a:ext cx="1945800" cy="1468080"/>
            </a:xfrm>
            <a:prstGeom prst="roundRect">
              <a:avLst>
                <a:gd name="adj" fmla="val 16667"/>
              </a:avLst>
            </a:prstGeom>
            <a:solidFill>
              <a:srgbClr val="ffcccc">
                <a:alpha val="30000"/>
              </a:srgbClr>
            </a:solidFill>
            <a:ln w="9360">
              <a:solidFill>
                <a:srgbClr val="faa08e">
                  <a:alpha val="0"/>
                </a:srgbClr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à coins arrondis 208"/>
            <p:cNvSpPr/>
            <p:nvPr/>
          </p:nvSpPr>
          <p:spPr>
            <a:xfrm>
              <a:off x="4214520" y="6091200"/>
              <a:ext cx="3747600" cy="456480"/>
            </a:xfrm>
            <a:prstGeom prst="roundRect">
              <a:avLst>
                <a:gd name="adj" fmla="val 16667"/>
              </a:avLst>
            </a:prstGeom>
            <a:solidFill>
              <a:srgbClr val="ffcccc">
                <a:alpha val="30000"/>
              </a:srgbClr>
            </a:solidFill>
            <a:ln w="9360">
              <a:solidFill>
                <a:srgbClr val="faa08e">
                  <a:alpha val="0"/>
                </a:srgbClr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à coins arrondis 209"/>
            <p:cNvSpPr/>
            <p:nvPr/>
          </p:nvSpPr>
          <p:spPr>
            <a:xfrm>
              <a:off x="4143240" y="3331800"/>
              <a:ext cx="3829680" cy="2546640"/>
            </a:xfrm>
            <a:prstGeom prst="roundRect">
              <a:avLst>
                <a:gd name="adj" fmla="val 16667"/>
              </a:avLst>
            </a:prstGeom>
            <a:solidFill>
              <a:srgbClr val="ffcccc">
                <a:alpha val="30000"/>
              </a:srgbClr>
            </a:solidFill>
            <a:ln w="9360">
              <a:solidFill>
                <a:srgbClr val="faa08e">
                  <a:alpha val="0"/>
                </a:srgbClr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Grouper 48"/>
            <p:cNvGrpSpPr/>
            <p:nvPr/>
          </p:nvGrpSpPr>
          <p:grpSpPr>
            <a:xfrm>
              <a:off x="1332720" y="476280"/>
              <a:ext cx="1296000" cy="6381720"/>
              <a:chOff x="1332720" y="476280"/>
              <a:chExt cx="1296000" cy="6381720"/>
            </a:xfrm>
          </p:grpSpPr>
          <p:sp>
            <p:nvSpPr>
              <p:cNvPr id="46" name="Forme libre 234"/>
              <p:cNvSpPr/>
              <p:nvPr/>
            </p:nvSpPr>
            <p:spPr>
              <a:xfrm>
                <a:off x="1332720" y="476280"/>
                <a:ext cx="1212120" cy="6381720"/>
              </a:xfrm>
              <a:custGeom>
                <a:avLst/>
                <a:gdLst>
                  <a:gd name="textAreaLeft" fmla="*/ 0 w 1212120"/>
                  <a:gd name="textAreaRight" fmla="*/ 1212480 w 1212120"/>
                  <a:gd name="textAreaTop" fmla="*/ 0 h 6381720"/>
                  <a:gd name="textAreaBottom" fmla="*/ 6382080 h 6381720"/>
                </a:gdLst>
                <a:ahLst/>
                <a:rect l="textAreaLeft" t="textAreaTop" r="textAreaRight" b="textAreaBottom"/>
                <a:pathLst>
                  <a:path w="1278466" h="6417733">
                    <a:moveTo>
                      <a:pt x="920044" y="0"/>
                    </a:moveTo>
                    <a:cubicBezTo>
                      <a:pt x="671688" y="277989"/>
                      <a:pt x="423333" y="555978"/>
                      <a:pt x="276577" y="1049867"/>
                    </a:cubicBezTo>
                    <a:cubicBezTo>
                      <a:pt x="129822" y="1543756"/>
                      <a:pt x="79022" y="2421466"/>
                      <a:pt x="39511" y="2963333"/>
                    </a:cubicBezTo>
                    <a:cubicBezTo>
                      <a:pt x="0" y="3505200"/>
                      <a:pt x="19756" y="4004734"/>
                      <a:pt x="39511" y="4301067"/>
                    </a:cubicBezTo>
                    <a:cubicBezTo>
                      <a:pt x="59266" y="4597400"/>
                      <a:pt x="79022" y="4667955"/>
                      <a:pt x="158044" y="4741333"/>
                    </a:cubicBezTo>
                    <a:cubicBezTo>
                      <a:pt x="237066" y="4814711"/>
                      <a:pt x="414866" y="4800600"/>
                      <a:pt x="513644" y="4741333"/>
                    </a:cubicBezTo>
                    <a:cubicBezTo>
                      <a:pt x="612422" y="4682066"/>
                      <a:pt x="646289" y="4425244"/>
                      <a:pt x="750711" y="4385733"/>
                    </a:cubicBezTo>
                    <a:cubicBezTo>
                      <a:pt x="855133" y="4346222"/>
                      <a:pt x="1061155" y="4346223"/>
                      <a:pt x="1140177" y="4504267"/>
                    </a:cubicBezTo>
                    <a:cubicBezTo>
                      <a:pt x="1219199" y="4662311"/>
                      <a:pt x="1278466" y="5136445"/>
                      <a:pt x="1224844" y="5334000"/>
                    </a:cubicBezTo>
                    <a:cubicBezTo>
                      <a:pt x="1171222" y="5531555"/>
                      <a:pt x="951088" y="5672667"/>
                      <a:pt x="818444" y="5689600"/>
                    </a:cubicBezTo>
                    <a:cubicBezTo>
                      <a:pt x="685800" y="5706533"/>
                      <a:pt x="496710" y="5545667"/>
                      <a:pt x="428977" y="5435600"/>
                    </a:cubicBezTo>
                    <a:cubicBezTo>
                      <a:pt x="361244" y="5325533"/>
                      <a:pt x="462844" y="5122333"/>
                      <a:pt x="412044" y="5029200"/>
                    </a:cubicBezTo>
                    <a:cubicBezTo>
                      <a:pt x="361244" y="4936067"/>
                      <a:pt x="174977" y="4763911"/>
                      <a:pt x="124177" y="4876800"/>
                    </a:cubicBezTo>
                    <a:cubicBezTo>
                      <a:pt x="73377" y="4989689"/>
                      <a:pt x="87488" y="5475111"/>
                      <a:pt x="107244" y="5706533"/>
                    </a:cubicBezTo>
                    <a:cubicBezTo>
                      <a:pt x="127000" y="5937955"/>
                      <a:pt x="191911" y="6146800"/>
                      <a:pt x="242711" y="6265333"/>
                    </a:cubicBezTo>
                    <a:cubicBezTo>
                      <a:pt x="293511" y="6383866"/>
                      <a:pt x="352777" y="6400799"/>
                      <a:pt x="412044" y="6417733"/>
                    </a:cubicBezTo>
                  </a:path>
                </a:pathLst>
              </a:custGeom>
              <a:noFill/>
              <a:ln w="25560">
                <a:solidFill>
                  <a:srgbClr val="ffffff"/>
                </a:solidFill>
                <a:miter/>
              </a:ln>
              <a:effectLst>
                <a:outerShdw dist="20160" dir="5400000" blurRad="0" rotWithShape="0">
                  <a:srgbClr val="808080">
                    <a:alpha val="38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Forme libre 235"/>
              <p:cNvSpPr/>
              <p:nvPr/>
            </p:nvSpPr>
            <p:spPr>
              <a:xfrm>
                <a:off x="1415160" y="476280"/>
                <a:ext cx="1213560" cy="6381720"/>
              </a:xfrm>
              <a:custGeom>
                <a:avLst/>
                <a:gdLst>
                  <a:gd name="textAreaLeft" fmla="*/ 0 w 1213560"/>
                  <a:gd name="textAreaRight" fmla="*/ 1213920 w 1213560"/>
                  <a:gd name="textAreaTop" fmla="*/ 0 h 6381720"/>
                  <a:gd name="textAreaBottom" fmla="*/ 6382080 h 6381720"/>
                </a:gdLst>
                <a:ahLst/>
                <a:rect l="textAreaLeft" t="textAreaTop" r="textAreaRight" b="textAreaBottom"/>
                <a:pathLst>
                  <a:path w="1278466" h="6417733">
                    <a:moveTo>
                      <a:pt x="920044" y="0"/>
                    </a:moveTo>
                    <a:cubicBezTo>
                      <a:pt x="671688" y="277989"/>
                      <a:pt x="423333" y="555978"/>
                      <a:pt x="276577" y="1049867"/>
                    </a:cubicBezTo>
                    <a:cubicBezTo>
                      <a:pt x="129822" y="1543756"/>
                      <a:pt x="79022" y="2421466"/>
                      <a:pt x="39511" y="2963333"/>
                    </a:cubicBezTo>
                    <a:cubicBezTo>
                      <a:pt x="0" y="3505200"/>
                      <a:pt x="19756" y="4004734"/>
                      <a:pt x="39511" y="4301067"/>
                    </a:cubicBezTo>
                    <a:cubicBezTo>
                      <a:pt x="59266" y="4597400"/>
                      <a:pt x="79022" y="4667955"/>
                      <a:pt x="158044" y="4741333"/>
                    </a:cubicBezTo>
                    <a:cubicBezTo>
                      <a:pt x="237066" y="4814711"/>
                      <a:pt x="414866" y="4800600"/>
                      <a:pt x="513644" y="4741333"/>
                    </a:cubicBezTo>
                    <a:cubicBezTo>
                      <a:pt x="612422" y="4682066"/>
                      <a:pt x="646289" y="4425244"/>
                      <a:pt x="750711" y="4385733"/>
                    </a:cubicBezTo>
                    <a:cubicBezTo>
                      <a:pt x="855133" y="4346222"/>
                      <a:pt x="1061155" y="4346223"/>
                      <a:pt x="1140177" y="4504267"/>
                    </a:cubicBezTo>
                    <a:cubicBezTo>
                      <a:pt x="1219199" y="4662311"/>
                      <a:pt x="1278466" y="5136445"/>
                      <a:pt x="1224844" y="5334000"/>
                    </a:cubicBezTo>
                    <a:cubicBezTo>
                      <a:pt x="1171222" y="5531555"/>
                      <a:pt x="951088" y="5672667"/>
                      <a:pt x="818444" y="5689600"/>
                    </a:cubicBezTo>
                    <a:cubicBezTo>
                      <a:pt x="685800" y="5706533"/>
                      <a:pt x="496710" y="5545667"/>
                      <a:pt x="428977" y="5435600"/>
                    </a:cubicBezTo>
                    <a:cubicBezTo>
                      <a:pt x="361244" y="5325533"/>
                      <a:pt x="462844" y="5122333"/>
                      <a:pt x="412044" y="5029200"/>
                    </a:cubicBezTo>
                    <a:cubicBezTo>
                      <a:pt x="361244" y="4936067"/>
                      <a:pt x="174977" y="4763911"/>
                      <a:pt x="124177" y="4876800"/>
                    </a:cubicBezTo>
                    <a:cubicBezTo>
                      <a:pt x="73377" y="4989689"/>
                      <a:pt x="87488" y="5475111"/>
                      <a:pt x="107244" y="5706533"/>
                    </a:cubicBezTo>
                    <a:cubicBezTo>
                      <a:pt x="127000" y="5937955"/>
                      <a:pt x="191911" y="6146800"/>
                      <a:pt x="242711" y="6265333"/>
                    </a:cubicBezTo>
                    <a:cubicBezTo>
                      <a:pt x="293511" y="6383866"/>
                      <a:pt x="352777" y="6400799"/>
                      <a:pt x="412044" y="6417733"/>
                    </a:cubicBezTo>
                  </a:path>
                </a:pathLst>
              </a:custGeom>
              <a:noFill/>
              <a:ln w="25560">
                <a:solidFill>
                  <a:srgbClr val="ffffff"/>
                </a:solidFill>
                <a:miter/>
              </a:ln>
              <a:effectLst>
                <a:outerShdw dist="20160" dir="5400000" blurRad="0" rotWithShape="0">
                  <a:srgbClr val="808080">
                    <a:alpha val="38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Flèche droite rayée 7"/>
            <p:cNvGrpSpPr/>
            <p:nvPr/>
          </p:nvGrpSpPr>
          <p:grpSpPr>
            <a:xfrm>
              <a:off x="195120" y="548280"/>
              <a:ext cx="1123200" cy="847800"/>
              <a:chOff x="195120" y="548280"/>
              <a:chExt cx="1123200" cy="847800"/>
            </a:xfrm>
          </p:grpSpPr>
          <p:pic>
            <p:nvPicPr>
              <p:cNvPr id="49" name="Flèche droite rayée 7" descr=""/>
              <p:cNvPicPr/>
              <p:nvPr/>
            </p:nvPicPr>
            <p:blipFill>
              <a:blip r:embed="rId1"/>
              <a:stretch/>
            </p:blipFill>
            <p:spPr>
              <a:xfrm>
                <a:off x="195120" y="548280"/>
                <a:ext cx="1123200" cy="847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"/>
              <p:cNvSpPr/>
              <p:nvPr/>
            </p:nvSpPr>
            <p:spPr>
              <a:xfrm>
                <a:off x="385200" y="766800"/>
                <a:ext cx="665280" cy="369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1" name="Flèche droite rayée 8"/>
            <p:cNvGrpSpPr/>
            <p:nvPr/>
          </p:nvGrpSpPr>
          <p:grpSpPr>
            <a:xfrm>
              <a:off x="-23760" y="1956600"/>
              <a:ext cx="1123200" cy="847800"/>
              <a:chOff x="-23760" y="1956600"/>
              <a:chExt cx="1123200" cy="847800"/>
            </a:xfrm>
          </p:grpSpPr>
          <p:pic>
            <p:nvPicPr>
              <p:cNvPr id="52" name="Flèche droite rayée 8" descr=""/>
              <p:cNvPicPr/>
              <p:nvPr/>
            </p:nvPicPr>
            <p:blipFill>
              <a:blip r:embed="rId2"/>
              <a:stretch/>
            </p:blipFill>
            <p:spPr>
              <a:xfrm>
                <a:off x="-23760" y="1956600"/>
                <a:ext cx="1123200" cy="847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"/>
              <p:cNvSpPr/>
              <p:nvPr/>
            </p:nvSpPr>
            <p:spPr>
              <a:xfrm>
                <a:off x="166680" y="2176560"/>
                <a:ext cx="665280" cy="369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" name="Ellipse 238"/>
            <p:cNvGrpSpPr/>
            <p:nvPr/>
          </p:nvGrpSpPr>
          <p:grpSpPr>
            <a:xfrm>
              <a:off x="1555200" y="542520"/>
              <a:ext cx="848160" cy="390240"/>
              <a:chOff x="1555200" y="542520"/>
              <a:chExt cx="848160" cy="390240"/>
            </a:xfrm>
          </p:grpSpPr>
          <p:pic>
            <p:nvPicPr>
              <p:cNvPr id="55" name="Ellipse 238" descr=""/>
              <p:cNvPicPr/>
              <p:nvPr/>
            </p:nvPicPr>
            <p:blipFill>
              <a:blip r:embed="rId3"/>
              <a:stretch/>
            </p:blipFill>
            <p:spPr>
              <a:xfrm>
                <a:off x="1555200" y="542520"/>
                <a:ext cx="848160" cy="390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"/>
              <p:cNvSpPr/>
              <p:nvPr/>
            </p:nvSpPr>
            <p:spPr>
              <a:xfrm>
                <a:off x="1725480" y="623520"/>
                <a:ext cx="510120" cy="190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LA-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7" name="Ellipse 239"/>
            <p:cNvGrpSpPr/>
            <p:nvPr/>
          </p:nvGrpSpPr>
          <p:grpSpPr>
            <a:xfrm>
              <a:off x="1342080" y="1218960"/>
              <a:ext cx="676800" cy="309960"/>
              <a:chOff x="1342080" y="1218960"/>
              <a:chExt cx="676800" cy="309960"/>
            </a:xfrm>
          </p:grpSpPr>
          <p:pic>
            <p:nvPicPr>
              <p:cNvPr id="58" name="Ellipse 239" descr=""/>
              <p:cNvPicPr/>
              <p:nvPr/>
            </p:nvPicPr>
            <p:blipFill>
              <a:blip r:embed="rId4"/>
              <a:stretch/>
            </p:blipFill>
            <p:spPr>
              <a:xfrm>
                <a:off x="1342080" y="1218960"/>
                <a:ext cx="676800" cy="309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9" name=""/>
              <p:cNvSpPr/>
              <p:nvPr/>
            </p:nvSpPr>
            <p:spPr>
              <a:xfrm>
                <a:off x="1486440" y="1283760"/>
                <a:ext cx="397440" cy="141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I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0" name="Ellipse 240"/>
            <p:cNvGrpSpPr/>
            <p:nvPr/>
          </p:nvGrpSpPr>
          <p:grpSpPr>
            <a:xfrm>
              <a:off x="1415160" y="950400"/>
              <a:ext cx="689400" cy="347040"/>
              <a:chOff x="1415160" y="950400"/>
              <a:chExt cx="689400" cy="347040"/>
            </a:xfrm>
          </p:grpSpPr>
          <p:pic>
            <p:nvPicPr>
              <p:cNvPr id="61" name="Ellipse 240" descr=""/>
              <p:cNvPicPr/>
              <p:nvPr/>
            </p:nvPicPr>
            <p:blipFill>
              <a:blip r:embed="rId5"/>
              <a:stretch/>
            </p:blipFill>
            <p:spPr>
              <a:xfrm>
                <a:off x="1415160" y="950400"/>
                <a:ext cx="689400" cy="34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2" name=""/>
              <p:cNvSpPr/>
              <p:nvPr/>
            </p:nvSpPr>
            <p:spPr>
              <a:xfrm>
                <a:off x="1561320" y="1022040"/>
                <a:ext cx="4068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D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3" name="Ellipse 242"/>
            <p:cNvGrpSpPr/>
            <p:nvPr/>
          </p:nvGrpSpPr>
          <p:grpSpPr>
            <a:xfrm>
              <a:off x="865440" y="2463120"/>
              <a:ext cx="817920" cy="317520"/>
              <a:chOff x="865440" y="2463120"/>
              <a:chExt cx="817920" cy="317520"/>
            </a:xfrm>
          </p:grpSpPr>
          <p:pic>
            <p:nvPicPr>
              <p:cNvPr id="64" name="Ellipse 242" descr=""/>
              <p:cNvPicPr/>
              <p:nvPr/>
            </p:nvPicPr>
            <p:blipFill>
              <a:blip r:embed="rId6"/>
              <a:stretch/>
            </p:blipFill>
            <p:spPr>
              <a:xfrm>
                <a:off x="865440" y="2463120"/>
                <a:ext cx="81792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" name=""/>
              <p:cNvSpPr/>
              <p:nvPr/>
            </p:nvSpPr>
            <p:spPr>
              <a:xfrm>
                <a:off x="1033200" y="2536200"/>
                <a:ext cx="489960" cy="13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2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6" name="Ellipse 243"/>
            <p:cNvGrpSpPr/>
            <p:nvPr/>
          </p:nvGrpSpPr>
          <p:grpSpPr>
            <a:xfrm>
              <a:off x="2019240" y="804240"/>
              <a:ext cx="646560" cy="707400"/>
              <a:chOff x="2019240" y="804240"/>
              <a:chExt cx="646560" cy="707400"/>
            </a:xfrm>
          </p:grpSpPr>
          <p:pic>
            <p:nvPicPr>
              <p:cNvPr id="67" name="Ellipse 243" descr=""/>
              <p:cNvPicPr/>
              <p:nvPr/>
            </p:nvPicPr>
            <p:blipFill>
              <a:blip r:embed="rId7"/>
              <a:stretch/>
            </p:blipFill>
            <p:spPr>
              <a:xfrm>
                <a:off x="2019240" y="804240"/>
                <a:ext cx="646560" cy="707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8" name=""/>
              <p:cNvSpPr/>
              <p:nvPr/>
            </p:nvSpPr>
            <p:spPr>
              <a:xfrm rot="18605400">
                <a:off x="2093040" y="1018800"/>
                <a:ext cx="504720" cy="237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HP-1/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9" name="Ellipse 245"/>
            <p:cNvGrpSpPr/>
            <p:nvPr/>
          </p:nvGrpSpPr>
          <p:grpSpPr>
            <a:xfrm>
              <a:off x="5019840" y="1353600"/>
              <a:ext cx="786240" cy="372240"/>
              <a:chOff x="5019840" y="1353600"/>
              <a:chExt cx="786240" cy="372240"/>
            </a:xfrm>
          </p:grpSpPr>
          <p:pic>
            <p:nvPicPr>
              <p:cNvPr id="70" name="Ellipse 245" descr=""/>
              <p:cNvPicPr/>
              <p:nvPr/>
            </p:nvPicPr>
            <p:blipFill>
              <a:blip r:embed="rId8"/>
              <a:stretch/>
            </p:blipFill>
            <p:spPr>
              <a:xfrm>
                <a:off x="5019840" y="1353600"/>
                <a:ext cx="786240" cy="372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1" name=""/>
              <p:cNvSpPr/>
              <p:nvPr/>
            </p:nvSpPr>
            <p:spPr>
              <a:xfrm>
                <a:off x="5177520" y="1427760"/>
                <a:ext cx="473760" cy="18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AP1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" name="Ellipse 246"/>
            <p:cNvGrpSpPr/>
            <p:nvPr/>
          </p:nvGrpSpPr>
          <p:grpSpPr>
            <a:xfrm>
              <a:off x="1696680" y="2956320"/>
              <a:ext cx="706680" cy="335160"/>
              <a:chOff x="1696680" y="2956320"/>
              <a:chExt cx="706680" cy="335160"/>
            </a:xfrm>
          </p:grpSpPr>
          <p:pic>
            <p:nvPicPr>
              <p:cNvPr id="73" name="Ellipse 246" descr=""/>
              <p:cNvPicPr/>
              <p:nvPr/>
            </p:nvPicPr>
            <p:blipFill>
              <a:blip r:embed="rId9"/>
              <a:stretch/>
            </p:blipFill>
            <p:spPr>
              <a:xfrm>
                <a:off x="1696680" y="2956320"/>
                <a:ext cx="706680" cy="335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4" name=""/>
              <p:cNvSpPr/>
              <p:nvPr/>
            </p:nvSpPr>
            <p:spPr>
              <a:xfrm>
                <a:off x="1850040" y="3027960"/>
                <a:ext cx="407160" cy="15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yn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5" name="Ellipse 247"/>
            <p:cNvGrpSpPr/>
            <p:nvPr/>
          </p:nvGrpSpPr>
          <p:grpSpPr>
            <a:xfrm>
              <a:off x="1110240" y="2646360"/>
              <a:ext cx="805320" cy="286200"/>
              <a:chOff x="1110240" y="2646360"/>
              <a:chExt cx="805320" cy="286200"/>
            </a:xfrm>
          </p:grpSpPr>
          <p:pic>
            <p:nvPicPr>
              <p:cNvPr id="76" name="Ellipse 247" descr=""/>
              <p:cNvPicPr/>
              <p:nvPr/>
            </p:nvPicPr>
            <p:blipFill>
              <a:blip r:embed="rId10"/>
              <a:stretch/>
            </p:blipFill>
            <p:spPr>
              <a:xfrm>
                <a:off x="1110240" y="2646360"/>
                <a:ext cx="805320" cy="286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7" name=""/>
              <p:cNvSpPr/>
              <p:nvPr/>
            </p:nvSpPr>
            <p:spPr>
              <a:xfrm rot="21437400">
                <a:off x="1274040" y="2712600"/>
                <a:ext cx="485280" cy="112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yk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8" name="Ellipse 248"/>
            <p:cNvGrpSpPr/>
            <p:nvPr/>
          </p:nvGrpSpPr>
          <p:grpSpPr>
            <a:xfrm>
              <a:off x="3324960" y="4254840"/>
              <a:ext cx="798840" cy="347040"/>
              <a:chOff x="3324960" y="4254840"/>
              <a:chExt cx="798840" cy="347040"/>
            </a:xfrm>
          </p:grpSpPr>
          <p:pic>
            <p:nvPicPr>
              <p:cNvPr id="79" name="Ellipse 248" descr=""/>
              <p:cNvPicPr/>
              <p:nvPr/>
            </p:nvPicPr>
            <p:blipFill>
              <a:blip r:embed="rId11"/>
              <a:stretch/>
            </p:blipFill>
            <p:spPr>
              <a:xfrm>
                <a:off x="3324960" y="4254840"/>
                <a:ext cx="798840" cy="34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0" name=""/>
              <p:cNvSpPr/>
              <p:nvPr/>
            </p:nvSpPr>
            <p:spPr>
              <a:xfrm>
                <a:off x="3486960" y="4327560"/>
                <a:ext cx="482760" cy="167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LC-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" name="Ellipse 250"/>
            <p:cNvGrpSpPr/>
            <p:nvPr/>
          </p:nvGrpSpPr>
          <p:grpSpPr>
            <a:xfrm>
              <a:off x="4861080" y="2755440"/>
              <a:ext cx="713160" cy="401760"/>
              <a:chOff x="4861080" y="2755440"/>
              <a:chExt cx="713160" cy="401760"/>
            </a:xfrm>
          </p:grpSpPr>
          <p:pic>
            <p:nvPicPr>
              <p:cNvPr id="82" name="Ellipse 250" descr=""/>
              <p:cNvPicPr/>
              <p:nvPr/>
            </p:nvPicPr>
            <p:blipFill>
              <a:blip r:embed="rId12"/>
              <a:stretch/>
            </p:blipFill>
            <p:spPr>
              <a:xfrm>
                <a:off x="4861080" y="2755440"/>
                <a:ext cx="713160" cy="401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3" name=""/>
              <p:cNvSpPr/>
              <p:nvPr/>
            </p:nvSpPr>
            <p:spPr>
              <a:xfrm>
                <a:off x="5015160" y="2838240"/>
                <a:ext cx="410760" cy="200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av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4" name="Ellipse 251"/>
            <p:cNvGrpSpPr/>
            <p:nvPr/>
          </p:nvGrpSpPr>
          <p:grpSpPr>
            <a:xfrm>
              <a:off x="5745960" y="3328560"/>
              <a:ext cx="762480" cy="407520"/>
              <a:chOff x="5745960" y="3328560"/>
              <a:chExt cx="762480" cy="407520"/>
            </a:xfrm>
          </p:grpSpPr>
          <p:pic>
            <p:nvPicPr>
              <p:cNvPr id="85" name="Ellipse 251" descr=""/>
              <p:cNvPicPr/>
              <p:nvPr/>
            </p:nvPicPr>
            <p:blipFill>
              <a:blip r:embed="rId13"/>
              <a:stretch/>
            </p:blipFill>
            <p:spPr>
              <a:xfrm>
                <a:off x="5745960" y="3328560"/>
                <a:ext cx="762480" cy="40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"/>
              <p:cNvSpPr/>
              <p:nvPr/>
            </p:nvSpPr>
            <p:spPr>
              <a:xfrm>
                <a:off x="5903640" y="3414600"/>
                <a:ext cx="449280" cy="200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a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7" name="Ellipse 253"/>
            <p:cNvGrpSpPr/>
            <p:nvPr/>
          </p:nvGrpSpPr>
          <p:grpSpPr>
            <a:xfrm>
              <a:off x="2794320" y="2687400"/>
              <a:ext cx="835200" cy="335160"/>
              <a:chOff x="2794320" y="2687400"/>
              <a:chExt cx="835200" cy="335160"/>
            </a:xfrm>
          </p:grpSpPr>
          <p:pic>
            <p:nvPicPr>
              <p:cNvPr id="88" name="Ellipse 253" descr=""/>
              <p:cNvPicPr/>
              <p:nvPr/>
            </p:nvPicPr>
            <p:blipFill>
              <a:blip r:embed="rId14"/>
              <a:stretch/>
            </p:blipFill>
            <p:spPr>
              <a:xfrm>
                <a:off x="2794320" y="2687400"/>
                <a:ext cx="835200" cy="335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" name=""/>
              <p:cNvSpPr/>
              <p:nvPr/>
            </p:nvSpPr>
            <p:spPr>
              <a:xfrm>
                <a:off x="2963160" y="2760840"/>
                <a:ext cx="499680" cy="151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ZAP-7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0" name="Ellipse 255"/>
            <p:cNvGrpSpPr/>
            <p:nvPr/>
          </p:nvGrpSpPr>
          <p:grpSpPr>
            <a:xfrm>
              <a:off x="2775240" y="2913480"/>
              <a:ext cx="854280" cy="323280"/>
              <a:chOff x="2775240" y="2913480"/>
              <a:chExt cx="854280" cy="323280"/>
            </a:xfrm>
          </p:grpSpPr>
          <p:pic>
            <p:nvPicPr>
              <p:cNvPr id="91" name="Ellipse 255" descr=""/>
              <p:cNvPicPr/>
              <p:nvPr/>
            </p:nvPicPr>
            <p:blipFill>
              <a:blip r:embed="rId15"/>
              <a:stretch/>
            </p:blipFill>
            <p:spPr>
              <a:xfrm>
                <a:off x="2775240" y="2913480"/>
                <a:ext cx="854280" cy="323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"/>
              <p:cNvSpPr/>
              <p:nvPr/>
            </p:nvSpPr>
            <p:spPr>
              <a:xfrm>
                <a:off x="2950560" y="2984040"/>
                <a:ext cx="510120" cy="14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yk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3" name="Ellipse 257"/>
            <p:cNvGrpSpPr/>
            <p:nvPr/>
          </p:nvGrpSpPr>
          <p:grpSpPr>
            <a:xfrm>
              <a:off x="3872880" y="2761560"/>
              <a:ext cx="848160" cy="401400"/>
              <a:chOff x="3872880" y="2761560"/>
              <a:chExt cx="848160" cy="401400"/>
            </a:xfrm>
          </p:grpSpPr>
          <p:pic>
            <p:nvPicPr>
              <p:cNvPr id="94" name="Ellipse 257" descr=""/>
              <p:cNvPicPr/>
              <p:nvPr/>
            </p:nvPicPr>
            <p:blipFill>
              <a:blip r:embed="rId16"/>
              <a:stretch/>
            </p:blipFill>
            <p:spPr>
              <a:xfrm>
                <a:off x="3872880" y="2761560"/>
                <a:ext cx="848160" cy="401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5" name=""/>
              <p:cNvSpPr/>
              <p:nvPr/>
            </p:nvSpPr>
            <p:spPr>
              <a:xfrm>
                <a:off x="4042800" y="2844360"/>
                <a:ext cx="510120" cy="200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CP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6" name="Ellipse 259"/>
            <p:cNvGrpSpPr/>
            <p:nvPr/>
          </p:nvGrpSpPr>
          <p:grpSpPr>
            <a:xfrm>
              <a:off x="2347920" y="3225240"/>
              <a:ext cx="713160" cy="401760"/>
              <a:chOff x="2347920" y="3225240"/>
              <a:chExt cx="713160" cy="401760"/>
            </a:xfrm>
          </p:grpSpPr>
          <p:pic>
            <p:nvPicPr>
              <p:cNvPr id="97" name="Ellipse 259" descr=""/>
              <p:cNvPicPr/>
              <p:nvPr/>
            </p:nvPicPr>
            <p:blipFill>
              <a:blip r:embed="rId17"/>
              <a:stretch/>
            </p:blipFill>
            <p:spPr>
              <a:xfrm>
                <a:off x="2347920" y="3225240"/>
                <a:ext cx="713160" cy="401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8" name=""/>
              <p:cNvSpPr/>
              <p:nvPr/>
            </p:nvSpPr>
            <p:spPr>
              <a:xfrm>
                <a:off x="2498760" y="3306960"/>
                <a:ext cx="417600" cy="200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A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9" name="Rectangle à coins arrondis 260"/>
            <p:cNvGrpSpPr/>
            <p:nvPr/>
          </p:nvGrpSpPr>
          <p:grpSpPr>
            <a:xfrm>
              <a:off x="5410800" y="3925440"/>
              <a:ext cx="1073520" cy="456120"/>
              <a:chOff x="5410800" y="3925440"/>
              <a:chExt cx="1073520" cy="456120"/>
            </a:xfrm>
          </p:grpSpPr>
          <p:pic>
            <p:nvPicPr>
              <p:cNvPr id="100" name="Rectangle à coins arrondis 260" descr=""/>
              <p:cNvPicPr/>
              <p:nvPr/>
            </p:nvPicPr>
            <p:blipFill>
              <a:blip r:embed="rId18"/>
              <a:stretch/>
            </p:blipFill>
            <p:spPr>
              <a:xfrm>
                <a:off x="5410800" y="3925440"/>
                <a:ext cx="1073520" cy="456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1" name=""/>
              <p:cNvSpPr/>
              <p:nvPr/>
            </p:nvSpPr>
            <p:spPr>
              <a:xfrm>
                <a:off x="5493600" y="3981240"/>
                <a:ext cx="915480" cy="303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APK signaling pathway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2" name="Ellipse 261"/>
            <p:cNvGrpSpPr/>
            <p:nvPr/>
          </p:nvGrpSpPr>
          <p:grpSpPr>
            <a:xfrm>
              <a:off x="7180560" y="3364200"/>
              <a:ext cx="835200" cy="389880"/>
              <a:chOff x="7180560" y="3364200"/>
              <a:chExt cx="835200" cy="389880"/>
            </a:xfrm>
          </p:grpSpPr>
          <p:pic>
            <p:nvPicPr>
              <p:cNvPr id="103" name="Ellipse 261" descr=""/>
              <p:cNvPicPr/>
              <p:nvPr/>
            </p:nvPicPr>
            <p:blipFill>
              <a:blip r:embed="rId19"/>
              <a:stretch/>
            </p:blipFill>
            <p:spPr>
              <a:xfrm>
                <a:off x="7180560" y="3364200"/>
                <a:ext cx="835200" cy="389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4" name=""/>
              <p:cNvSpPr/>
              <p:nvPr/>
            </p:nvSpPr>
            <p:spPr>
              <a:xfrm>
                <a:off x="7346880" y="3440160"/>
                <a:ext cx="509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RK1/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5" name="Ellipse 262"/>
            <p:cNvGrpSpPr/>
            <p:nvPr/>
          </p:nvGrpSpPr>
          <p:grpSpPr>
            <a:xfrm>
              <a:off x="6959520" y="2030040"/>
              <a:ext cx="768600" cy="401400"/>
              <a:chOff x="6959520" y="2030040"/>
              <a:chExt cx="768600" cy="401400"/>
            </a:xfrm>
          </p:grpSpPr>
          <p:pic>
            <p:nvPicPr>
              <p:cNvPr id="106" name="Ellipse 262" descr=""/>
              <p:cNvPicPr/>
              <p:nvPr/>
            </p:nvPicPr>
            <p:blipFill>
              <a:blip r:embed="rId20"/>
              <a:stretch/>
            </p:blipFill>
            <p:spPr>
              <a:xfrm>
                <a:off x="6959520" y="2030040"/>
                <a:ext cx="768600" cy="401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7" name=""/>
              <p:cNvSpPr/>
              <p:nvPr/>
            </p:nvSpPr>
            <p:spPr>
              <a:xfrm>
                <a:off x="7118280" y="2111400"/>
                <a:ext cx="456120" cy="200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i3K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8" name="Ellipse 263"/>
            <p:cNvGrpSpPr/>
            <p:nvPr/>
          </p:nvGrpSpPr>
          <p:grpSpPr>
            <a:xfrm>
              <a:off x="4282920" y="3553200"/>
              <a:ext cx="665280" cy="378000"/>
              <a:chOff x="4282920" y="3553200"/>
              <a:chExt cx="665280" cy="378000"/>
            </a:xfrm>
          </p:grpSpPr>
          <p:pic>
            <p:nvPicPr>
              <p:cNvPr id="109" name="Ellipse 263" descr=""/>
              <p:cNvPicPr/>
              <p:nvPr/>
            </p:nvPicPr>
            <p:blipFill>
              <a:blip r:embed="rId21"/>
              <a:stretch/>
            </p:blipFill>
            <p:spPr>
              <a:xfrm>
                <a:off x="4282920" y="3553200"/>
                <a:ext cx="665280" cy="378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0" name=""/>
              <p:cNvSpPr/>
              <p:nvPr/>
            </p:nvSpPr>
            <p:spPr>
              <a:xfrm>
                <a:off x="4426200" y="3632040"/>
                <a:ext cx="382320" cy="18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TK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1" name="Ellipse 264"/>
            <p:cNvGrpSpPr/>
            <p:nvPr/>
          </p:nvGrpSpPr>
          <p:grpSpPr>
            <a:xfrm>
              <a:off x="4867200" y="4816440"/>
              <a:ext cx="670320" cy="298440"/>
              <a:chOff x="4867200" y="4816440"/>
              <a:chExt cx="670320" cy="298440"/>
            </a:xfrm>
          </p:grpSpPr>
          <p:pic>
            <p:nvPicPr>
              <p:cNvPr id="112" name="Ellipse 264" descr=""/>
              <p:cNvPicPr/>
              <p:nvPr/>
            </p:nvPicPr>
            <p:blipFill>
              <a:blip r:embed="rId22"/>
              <a:stretch/>
            </p:blipFill>
            <p:spPr>
              <a:xfrm>
                <a:off x="4867200" y="4816440"/>
                <a:ext cx="670320" cy="298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3" name=""/>
              <p:cNvSpPr/>
              <p:nvPr/>
            </p:nvSpPr>
            <p:spPr>
              <a:xfrm>
                <a:off x="5014440" y="4885920"/>
                <a:ext cx="383760" cy="12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K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4" name="Rectangle à coins arrondis 266"/>
            <p:cNvGrpSpPr/>
            <p:nvPr/>
          </p:nvGrpSpPr>
          <p:grpSpPr>
            <a:xfrm>
              <a:off x="4923000" y="5290560"/>
              <a:ext cx="798840" cy="401760"/>
              <a:chOff x="4923000" y="5290560"/>
              <a:chExt cx="798840" cy="401760"/>
            </a:xfrm>
          </p:grpSpPr>
          <p:pic>
            <p:nvPicPr>
              <p:cNvPr id="115" name="Rectangle à coins arrondis 266" descr=""/>
              <p:cNvPicPr/>
              <p:nvPr/>
            </p:nvPicPr>
            <p:blipFill>
              <a:blip r:embed="rId23"/>
              <a:stretch/>
            </p:blipFill>
            <p:spPr>
              <a:xfrm>
                <a:off x="4923000" y="5290560"/>
                <a:ext cx="798840" cy="401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6" name=""/>
              <p:cNvSpPr/>
              <p:nvPr/>
            </p:nvSpPr>
            <p:spPr>
              <a:xfrm>
                <a:off x="4996080" y="5339520"/>
                <a:ext cx="657360" cy="266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a2+ releas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7" name="Rectangle à coins arrondis 267"/>
            <p:cNvGrpSpPr/>
            <p:nvPr/>
          </p:nvGrpSpPr>
          <p:grpSpPr>
            <a:xfrm>
              <a:off x="5917320" y="5272560"/>
              <a:ext cx="1000440" cy="444600"/>
              <a:chOff x="5917320" y="5272560"/>
              <a:chExt cx="1000440" cy="444600"/>
            </a:xfrm>
          </p:grpSpPr>
          <p:pic>
            <p:nvPicPr>
              <p:cNvPr id="118" name="Rectangle à coins arrondis 267" descr=""/>
              <p:cNvPicPr/>
              <p:nvPr/>
            </p:nvPicPr>
            <p:blipFill>
              <a:blip r:embed="rId24"/>
              <a:stretch/>
            </p:blipFill>
            <p:spPr>
              <a:xfrm>
                <a:off x="5917320" y="5272560"/>
                <a:ext cx="1000440" cy="444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9" name=""/>
              <p:cNvSpPr/>
              <p:nvPr/>
            </p:nvSpPr>
            <p:spPr>
              <a:xfrm>
                <a:off x="5995800" y="5325480"/>
                <a:ext cx="852120" cy="302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a2+ signaling pathway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0" name="ZoneTexte 48"/>
            <p:cNvSpPr/>
            <p:nvPr/>
          </p:nvSpPr>
          <p:spPr>
            <a:xfrm>
              <a:off x="287280" y="740520"/>
              <a:ext cx="93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nhibitory sign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ZoneTexte 49"/>
            <p:cNvSpPr/>
            <p:nvPr/>
          </p:nvSpPr>
          <p:spPr>
            <a:xfrm>
              <a:off x="82440" y="2154240"/>
              <a:ext cx="93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ctivation sign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2" name="Ellipse 270"/>
            <p:cNvGrpSpPr/>
            <p:nvPr/>
          </p:nvGrpSpPr>
          <p:grpSpPr>
            <a:xfrm>
              <a:off x="1408680" y="3309480"/>
              <a:ext cx="792720" cy="292320"/>
              <a:chOff x="1408680" y="3309480"/>
              <a:chExt cx="792720" cy="292320"/>
            </a:xfrm>
          </p:grpSpPr>
          <p:pic>
            <p:nvPicPr>
              <p:cNvPr id="123" name="Ellipse 270" descr=""/>
              <p:cNvPicPr/>
              <p:nvPr/>
            </p:nvPicPr>
            <p:blipFill>
              <a:blip r:embed="rId25"/>
              <a:stretch/>
            </p:blipFill>
            <p:spPr>
              <a:xfrm>
                <a:off x="1408680" y="3309480"/>
                <a:ext cx="792720" cy="292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4" name=""/>
              <p:cNvSpPr/>
              <p:nvPr/>
            </p:nvSpPr>
            <p:spPr>
              <a:xfrm>
                <a:off x="1573920" y="3378960"/>
                <a:ext cx="469440" cy="117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3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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5" name="Ellipse 271"/>
            <p:cNvGrpSpPr/>
            <p:nvPr/>
          </p:nvGrpSpPr>
          <p:grpSpPr>
            <a:xfrm>
              <a:off x="1421640" y="3162960"/>
              <a:ext cx="792360" cy="292320"/>
              <a:chOff x="1421640" y="3162960"/>
              <a:chExt cx="792360" cy="292320"/>
            </a:xfrm>
          </p:grpSpPr>
          <p:pic>
            <p:nvPicPr>
              <p:cNvPr id="126" name="Ellipse 271" descr=""/>
              <p:cNvPicPr/>
              <p:nvPr/>
            </p:nvPicPr>
            <p:blipFill>
              <a:blip r:embed="rId26"/>
              <a:stretch/>
            </p:blipFill>
            <p:spPr>
              <a:xfrm>
                <a:off x="1421640" y="3162960"/>
                <a:ext cx="792360" cy="292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7" name=""/>
              <p:cNvSpPr/>
              <p:nvPr/>
            </p:nvSpPr>
            <p:spPr>
              <a:xfrm>
                <a:off x="1585800" y="3232440"/>
                <a:ext cx="469080" cy="117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3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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128" name="Connecteur droit avec flèche 272"/>
            <p:cNvCxnSpPr/>
            <p:nvPr/>
          </p:nvCxnSpPr>
          <p:spPr>
            <a:xfrm flipV="1">
              <a:off x="2269440" y="2899800"/>
              <a:ext cx="580680" cy="3657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29" name="Connecteur droit avec flèche 273"/>
            <p:cNvCxnSpPr/>
            <p:nvPr/>
          </p:nvCxnSpPr>
          <p:spPr>
            <a:xfrm>
              <a:off x="3626640" y="2941200"/>
              <a:ext cx="216720" cy="18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30" name="Connecteur droit avec flèche 275"/>
            <p:cNvCxnSpPr/>
            <p:nvPr/>
          </p:nvCxnSpPr>
          <p:spPr>
            <a:xfrm>
              <a:off x="4684680" y="2941200"/>
              <a:ext cx="216720" cy="18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131" name="Ellipse 276"/>
            <p:cNvGrpSpPr/>
            <p:nvPr/>
          </p:nvGrpSpPr>
          <p:grpSpPr>
            <a:xfrm>
              <a:off x="5758560" y="2730240"/>
              <a:ext cx="895680" cy="469800"/>
              <a:chOff x="5758560" y="2730240"/>
              <a:chExt cx="895680" cy="469800"/>
            </a:xfrm>
          </p:grpSpPr>
          <p:pic>
            <p:nvPicPr>
              <p:cNvPr id="132" name="Ellipse 276" descr=""/>
              <p:cNvPicPr/>
              <p:nvPr/>
            </p:nvPicPr>
            <p:blipFill>
              <a:blip r:embed="rId27"/>
              <a:stretch/>
            </p:blipFill>
            <p:spPr>
              <a:xfrm>
                <a:off x="5758560" y="2730240"/>
                <a:ext cx="895680" cy="469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3" name=""/>
              <p:cNvSpPr/>
              <p:nvPr/>
            </p:nvSpPr>
            <p:spPr>
              <a:xfrm>
                <a:off x="5940000" y="2824920"/>
                <a:ext cx="539640" cy="24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ho/ CDC4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134" name="Connecteur droit avec flèche 277"/>
            <p:cNvCxnSpPr/>
            <p:nvPr/>
          </p:nvCxnSpPr>
          <p:spPr>
            <a:xfrm>
              <a:off x="5583960" y="2941200"/>
              <a:ext cx="216720" cy="18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135" name="Ellipse 278"/>
            <p:cNvGrpSpPr/>
            <p:nvPr/>
          </p:nvGrpSpPr>
          <p:grpSpPr>
            <a:xfrm>
              <a:off x="3335760" y="3547440"/>
              <a:ext cx="726120" cy="395640"/>
              <a:chOff x="3335760" y="3547440"/>
              <a:chExt cx="726120" cy="395640"/>
            </a:xfrm>
          </p:grpSpPr>
          <p:pic>
            <p:nvPicPr>
              <p:cNvPr id="136" name="Ellipse 278" descr=""/>
              <p:cNvPicPr/>
              <p:nvPr/>
            </p:nvPicPr>
            <p:blipFill>
              <a:blip r:embed="rId28"/>
              <a:stretch/>
            </p:blipFill>
            <p:spPr>
              <a:xfrm>
                <a:off x="3335760" y="3547440"/>
                <a:ext cx="726120" cy="395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7" name=""/>
              <p:cNvSpPr/>
              <p:nvPr/>
            </p:nvSpPr>
            <p:spPr>
              <a:xfrm>
                <a:off x="3487680" y="3625200"/>
                <a:ext cx="430200" cy="200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b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138" name="Connecteur droit avec flèche 279"/>
            <p:cNvCxnSpPr/>
            <p:nvPr/>
          </p:nvCxnSpPr>
          <p:spPr>
            <a:xfrm flipH="1">
              <a:off x="2833200" y="3136680"/>
              <a:ext cx="119880" cy="15552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139" name="Ellipse 280"/>
            <p:cNvGrpSpPr/>
            <p:nvPr/>
          </p:nvGrpSpPr>
          <p:grpSpPr>
            <a:xfrm>
              <a:off x="3361320" y="4005360"/>
              <a:ext cx="689400" cy="303840"/>
              <a:chOff x="3361320" y="4005360"/>
              <a:chExt cx="689400" cy="303840"/>
            </a:xfrm>
          </p:grpSpPr>
          <p:pic>
            <p:nvPicPr>
              <p:cNvPr id="140" name="Ellipse 280" descr=""/>
              <p:cNvPicPr/>
              <p:nvPr/>
            </p:nvPicPr>
            <p:blipFill>
              <a:blip r:embed="rId29"/>
              <a:stretch/>
            </p:blipFill>
            <p:spPr>
              <a:xfrm>
                <a:off x="3361320" y="4005360"/>
                <a:ext cx="689400" cy="303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1" name=""/>
              <p:cNvSpPr/>
              <p:nvPr/>
            </p:nvSpPr>
            <p:spPr>
              <a:xfrm>
                <a:off x="3505680" y="4072320"/>
                <a:ext cx="405720" cy="136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O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142" name="Connecteur droit avec flèche 281"/>
            <p:cNvCxnSpPr/>
            <p:nvPr/>
          </p:nvCxnSpPr>
          <p:spPr>
            <a:xfrm>
              <a:off x="2989080" y="3532320"/>
              <a:ext cx="369000" cy="101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43" name="Connecteur droit avec flèche 282"/>
            <p:cNvCxnSpPr/>
            <p:nvPr/>
          </p:nvCxnSpPr>
          <p:spPr>
            <a:xfrm>
              <a:off x="4070160" y="3733200"/>
              <a:ext cx="218160" cy="2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44" name="Connecteur droit avec flèche 283"/>
            <p:cNvCxnSpPr/>
            <p:nvPr/>
          </p:nvCxnSpPr>
          <p:spPr>
            <a:xfrm flipV="1">
              <a:off x="4792680" y="3195000"/>
              <a:ext cx="216720" cy="3358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145" name="Ellipse 284"/>
            <p:cNvGrpSpPr/>
            <p:nvPr/>
          </p:nvGrpSpPr>
          <p:grpSpPr>
            <a:xfrm>
              <a:off x="3434400" y="3206160"/>
              <a:ext cx="762120" cy="298440"/>
              <a:chOff x="3434400" y="3206160"/>
              <a:chExt cx="762120" cy="298440"/>
            </a:xfrm>
          </p:grpSpPr>
          <p:pic>
            <p:nvPicPr>
              <p:cNvPr id="146" name="Ellipse 284" descr=""/>
              <p:cNvPicPr/>
              <p:nvPr/>
            </p:nvPicPr>
            <p:blipFill>
              <a:blip r:embed="rId30"/>
              <a:stretch/>
            </p:blipFill>
            <p:spPr>
              <a:xfrm>
                <a:off x="3434400" y="3206160"/>
                <a:ext cx="762120" cy="298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7" name=""/>
              <p:cNvSpPr/>
              <p:nvPr/>
            </p:nvSpPr>
            <p:spPr>
              <a:xfrm>
                <a:off x="3589560" y="3271680"/>
                <a:ext cx="458280" cy="133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AD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148" name="Connecteur droit avec flèche 285"/>
            <p:cNvCxnSpPr/>
            <p:nvPr/>
          </p:nvCxnSpPr>
          <p:spPr>
            <a:xfrm flipV="1">
              <a:off x="3069000" y="3372120"/>
              <a:ext cx="394200" cy="435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49" name="Connecteur droit avec flèche 286"/>
            <p:cNvCxnSpPr/>
            <p:nvPr/>
          </p:nvCxnSpPr>
          <p:spPr>
            <a:xfrm flipV="1">
              <a:off x="3997800" y="3084480"/>
              <a:ext cx="151560" cy="1306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50" name="Connecteur droit avec flèche 287"/>
            <p:cNvCxnSpPr/>
            <p:nvPr/>
          </p:nvCxnSpPr>
          <p:spPr>
            <a:xfrm>
              <a:off x="2773440" y="3600720"/>
              <a:ext cx="563040" cy="8100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51" name="Connecteur droit avec flèche 288"/>
            <p:cNvCxnSpPr/>
            <p:nvPr/>
          </p:nvCxnSpPr>
          <p:spPr>
            <a:xfrm flipH="1">
              <a:off x="4069800" y="3884040"/>
              <a:ext cx="467280" cy="51912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152" name="Connecteur droit avec flèche 289"/>
            <p:cNvCxnSpPr/>
            <p:nvPr/>
          </p:nvCxnSpPr>
          <p:spPr>
            <a:xfrm flipH="1">
              <a:off x="3717000" y="3882600"/>
              <a:ext cx="2160" cy="1936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153" name="Ellipse 290"/>
            <p:cNvGrpSpPr/>
            <p:nvPr/>
          </p:nvGrpSpPr>
          <p:grpSpPr>
            <a:xfrm>
              <a:off x="4544640" y="4005360"/>
              <a:ext cx="707040" cy="323280"/>
              <a:chOff x="4544640" y="4005360"/>
              <a:chExt cx="707040" cy="323280"/>
            </a:xfrm>
          </p:grpSpPr>
          <p:pic>
            <p:nvPicPr>
              <p:cNvPr id="154" name="Ellipse 290" descr=""/>
              <p:cNvPicPr/>
              <p:nvPr/>
            </p:nvPicPr>
            <p:blipFill>
              <a:blip r:embed="rId31"/>
              <a:stretch/>
            </p:blipFill>
            <p:spPr>
              <a:xfrm>
                <a:off x="4544640" y="4005360"/>
                <a:ext cx="707040" cy="323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5" name=""/>
              <p:cNvSpPr/>
              <p:nvPr/>
            </p:nvSpPr>
            <p:spPr>
              <a:xfrm>
                <a:off x="4695840" y="4074840"/>
                <a:ext cx="407520" cy="14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A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6" name="Ellipse 291"/>
            <p:cNvGrpSpPr/>
            <p:nvPr/>
          </p:nvGrpSpPr>
          <p:grpSpPr>
            <a:xfrm>
              <a:off x="7167960" y="3986280"/>
              <a:ext cx="695520" cy="309960"/>
              <a:chOff x="7167960" y="3986280"/>
              <a:chExt cx="695520" cy="309960"/>
            </a:xfrm>
          </p:grpSpPr>
          <p:pic>
            <p:nvPicPr>
              <p:cNvPr id="157" name="Ellipse 291" descr=""/>
              <p:cNvPicPr/>
              <p:nvPr/>
            </p:nvPicPr>
            <p:blipFill>
              <a:blip r:embed="rId32"/>
              <a:stretch/>
            </p:blipFill>
            <p:spPr>
              <a:xfrm>
                <a:off x="7167960" y="3986280"/>
                <a:ext cx="695520" cy="309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8" name=""/>
              <p:cNvSpPr/>
              <p:nvPr/>
            </p:nvSpPr>
            <p:spPr>
              <a:xfrm>
                <a:off x="7315920" y="4051800"/>
                <a:ext cx="407880" cy="141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P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9" name="Rectangle à coins arrondis 294"/>
            <p:cNvGrpSpPr/>
            <p:nvPr/>
          </p:nvGrpSpPr>
          <p:grpSpPr>
            <a:xfrm>
              <a:off x="5691960" y="4687560"/>
              <a:ext cx="762480" cy="261360"/>
              <a:chOff x="5691960" y="4687560"/>
              <a:chExt cx="762480" cy="261360"/>
            </a:xfrm>
          </p:grpSpPr>
          <p:pic>
            <p:nvPicPr>
              <p:cNvPr id="160" name="Rectangle à coins arrondis 294" descr=""/>
              <p:cNvPicPr/>
              <p:nvPr/>
            </p:nvPicPr>
            <p:blipFill>
              <a:blip r:embed="rId33"/>
              <a:stretch/>
            </p:blipFill>
            <p:spPr>
              <a:xfrm>
                <a:off x="5691960" y="4687560"/>
                <a:ext cx="762480" cy="261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1" name=""/>
              <p:cNvSpPr/>
              <p:nvPr/>
            </p:nvSpPr>
            <p:spPr>
              <a:xfrm>
                <a:off x="5761080" y="4745880"/>
                <a:ext cx="634680" cy="12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ARMA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2" name="Rectangle à coins arrondis 296"/>
            <p:cNvGrpSpPr/>
            <p:nvPr/>
          </p:nvGrpSpPr>
          <p:grpSpPr>
            <a:xfrm>
              <a:off x="5685480" y="4822200"/>
              <a:ext cx="775080" cy="261360"/>
              <a:chOff x="5685480" y="4822200"/>
              <a:chExt cx="775080" cy="261360"/>
            </a:xfrm>
          </p:grpSpPr>
          <p:pic>
            <p:nvPicPr>
              <p:cNvPr id="163" name="Rectangle à coins arrondis 296" descr=""/>
              <p:cNvPicPr/>
              <p:nvPr/>
            </p:nvPicPr>
            <p:blipFill>
              <a:blip r:embed="rId34"/>
              <a:stretch/>
            </p:blipFill>
            <p:spPr>
              <a:xfrm>
                <a:off x="5685480" y="4822200"/>
                <a:ext cx="775080" cy="261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4" name=""/>
              <p:cNvSpPr/>
              <p:nvPr/>
            </p:nvSpPr>
            <p:spPr>
              <a:xfrm>
                <a:off x="5757120" y="4877640"/>
                <a:ext cx="636840" cy="12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CL1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5" name="Rectangle à coins arrondis 297"/>
            <p:cNvGrpSpPr/>
            <p:nvPr/>
          </p:nvGrpSpPr>
          <p:grpSpPr>
            <a:xfrm>
              <a:off x="5691960" y="4949280"/>
              <a:ext cx="762480" cy="261000"/>
              <a:chOff x="5691960" y="4949280"/>
              <a:chExt cx="762480" cy="261000"/>
            </a:xfrm>
          </p:grpSpPr>
          <p:pic>
            <p:nvPicPr>
              <p:cNvPr id="166" name="Rectangle à coins arrondis 297" descr=""/>
              <p:cNvPicPr/>
              <p:nvPr/>
            </p:nvPicPr>
            <p:blipFill>
              <a:blip r:embed="rId35"/>
              <a:stretch/>
            </p:blipFill>
            <p:spPr>
              <a:xfrm>
                <a:off x="5691960" y="4949280"/>
                <a:ext cx="762480" cy="261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7" name=""/>
              <p:cNvSpPr/>
              <p:nvPr/>
            </p:nvSpPr>
            <p:spPr>
              <a:xfrm>
                <a:off x="5760720" y="5010840"/>
                <a:ext cx="635400" cy="11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ALT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8" name="Rectangle à coins arrondis 299"/>
            <p:cNvGrpSpPr/>
            <p:nvPr/>
          </p:nvGrpSpPr>
          <p:grpSpPr>
            <a:xfrm>
              <a:off x="6594120" y="4676040"/>
              <a:ext cx="543240" cy="261000"/>
              <a:chOff x="6594120" y="4676040"/>
              <a:chExt cx="543240" cy="261000"/>
            </a:xfrm>
          </p:grpSpPr>
          <p:pic>
            <p:nvPicPr>
              <p:cNvPr id="169" name="Rectangle à coins arrondis 299" descr=""/>
              <p:cNvPicPr/>
              <p:nvPr/>
            </p:nvPicPr>
            <p:blipFill>
              <a:blip r:embed="rId36"/>
              <a:stretch/>
            </p:blipFill>
            <p:spPr>
              <a:xfrm>
                <a:off x="6594120" y="4676040"/>
                <a:ext cx="543240" cy="261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0" name=""/>
              <p:cNvSpPr/>
              <p:nvPr/>
            </p:nvSpPr>
            <p:spPr>
              <a:xfrm>
                <a:off x="6659280" y="4732920"/>
                <a:ext cx="419040" cy="12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KK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1" name="Rectangle à coins arrondis 301"/>
            <p:cNvGrpSpPr/>
            <p:nvPr/>
          </p:nvGrpSpPr>
          <p:grpSpPr>
            <a:xfrm>
              <a:off x="6587640" y="4808880"/>
              <a:ext cx="549720" cy="255600"/>
              <a:chOff x="6587640" y="4808880"/>
              <a:chExt cx="549720" cy="255600"/>
            </a:xfrm>
          </p:grpSpPr>
          <p:pic>
            <p:nvPicPr>
              <p:cNvPr id="172" name="Rectangle à coins arrondis 301" descr=""/>
              <p:cNvPicPr/>
              <p:nvPr/>
            </p:nvPicPr>
            <p:blipFill>
              <a:blip r:embed="rId37"/>
              <a:stretch/>
            </p:blipFill>
            <p:spPr>
              <a:xfrm>
                <a:off x="6587640" y="4808880"/>
                <a:ext cx="549720" cy="255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3" name=""/>
              <p:cNvSpPr/>
              <p:nvPr/>
            </p:nvSpPr>
            <p:spPr>
              <a:xfrm>
                <a:off x="6657480" y="4864680"/>
                <a:ext cx="419760" cy="12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KK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4" name="Rectangle à coins arrondis 302"/>
            <p:cNvGrpSpPr/>
            <p:nvPr/>
          </p:nvGrpSpPr>
          <p:grpSpPr>
            <a:xfrm>
              <a:off x="6594120" y="4943160"/>
              <a:ext cx="543240" cy="255600"/>
              <a:chOff x="6594120" y="4943160"/>
              <a:chExt cx="543240" cy="255600"/>
            </a:xfrm>
          </p:grpSpPr>
          <p:pic>
            <p:nvPicPr>
              <p:cNvPr id="175" name="Rectangle à coins arrondis 302" descr=""/>
              <p:cNvPicPr/>
              <p:nvPr/>
            </p:nvPicPr>
            <p:blipFill>
              <a:blip r:embed="rId38"/>
              <a:stretch/>
            </p:blipFill>
            <p:spPr>
              <a:xfrm>
                <a:off x="6594120" y="4943160"/>
                <a:ext cx="543240" cy="255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6" name=""/>
              <p:cNvSpPr/>
              <p:nvPr/>
            </p:nvSpPr>
            <p:spPr>
              <a:xfrm>
                <a:off x="6659280" y="4999320"/>
                <a:ext cx="419400" cy="12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KK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7" name="Rectangle à coins arrondis 304"/>
            <p:cNvGrpSpPr/>
            <p:nvPr/>
          </p:nvGrpSpPr>
          <p:grpSpPr>
            <a:xfrm>
              <a:off x="7301160" y="4822200"/>
              <a:ext cx="549720" cy="255600"/>
              <a:chOff x="7301160" y="4822200"/>
              <a:chExt cx="549720" cy="255600"/>
            </a:xfrm>
          </p:grpSpPr>
          <p:pic>
            <p:nvPicPr>
              <p:cNvPr id="178" name="Rectangle à coins arrondis 304" descr=""/>
              <p:cNvPicPr/>
              <p:nvPr/>
            </p:nvPicPr>
            <p:blipFill>
              <a:blip r:embed="rId39"/>
              <a:stretch/>
            </p:blipFill>
            <p:spPr>
              <a:xfrm>
                <a:off x="7301160" y="4822200"/>
                <a:ext cx="549720" cy="255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9" name=""/>
              <p:cNvSpPr/>
              <p:nvPr/>
            </p:nvSpPr>
            <p:spPr>
              <a:xfrm>
                <a:off x="7367400" y="4879080"/>
                <a:ext cx="421200" cy="12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K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0" name="Ellipse 305"/>
            <p:cNvGrpSpPr/>
            <p:nvPr/>
          </p:nvGrpSpPr>
          <p:grpSpPr>
            <a:xfrm>
              <a:off x="7148880" y="5346720"/>
              <a:ext cx="775080" cy="323280"/>
              <a:chOff x="7148880" y="5346720"/>
              <a:chExt cx="775080" cy="323280"/>
            </a:xfrm>
          </p:grpSpPr>
          <p:pic>
            <p:nvPicPr>
              <p:cNvPr id="181" name="Ellipse 305" descr=""/>
              <p:cNvPicPr/>
              <p:nvPr/>
            </p:nvPicPr>
            <p:blipFill>
              <a:blip r:embed="rId40"/>
              <a:stretch/>
            </p:blipFill>
            <p:spPr>
              <a:xfrm>
                <a:off x="7148880" y="5346720"/>
                <a:ext cx="775080" cy="323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2" name=""/>
              <p:cNvSpPr/>
              <p:nvPr/>
            </p:nvSpPr>
            <p:spPr>
              <a:xfrm>
                <a:off x="7309800" y="5418000"/>
                <a:ext cx="458640" cy="14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FA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3" name="Ellipse 306"/>
            <p:cNvGrpSpPr/>
            <p:nvPr/>
          </p:nvGrpSpPr>
          <p:grpSpPr>
            <a:xfrm>
              <a:off x="7161480" y="4364280"/>
              <a:ext cx="738720" cy="317520"/>
              <a:chOff x="7161480" y="4364280"/>
              <a:chExt cx="738720" cy="317520"/>
            </a:xfrm>
          </p:grpSpPr>
          <p:pic>
            <p:nvPicPr>
              <p:cNvPr id="184" name="Ellipse 306" descr=""/>
              <p:cNvPicPr/>
              <p:nvPr/>
            </p:nvPicPr>
            <p:blipFill>
              <a:blip r:embed="rId41"/>
              <a:stretch/>
            </p:blipFill>
            <p:spPr>
              <a:xfrm>
                <a:off x="7161480" y="4364280"/>
                <a:ext cx="73872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5" name=""/>
              <p:cNvSpPr/>
              <p:nvPr/>
            </p:nvSpPr>
            <p:spPr>
              <a:xfrm>
                <a:off x="7311240" y="4433760"/>
                <a:ext cx="440640" cy="14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FK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186" name="Connecteur en arc 129"/>
            <p:cNvCxnSpPr/>
            <p:nvPr/>
          </p:nvCxnSpPr>
          <p:spPr>
            <a:xfrm rot="5400000">
              <a:off x="4599360" y="5019480"/>
              <a:ext cx="123120" cy="1326960"/>
            </a:xfrm>
            <a:prstGeom prst="curvedConnector2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187" name="Ellipse 308"/>
            <p:cNvSpPr/>
            <p:nvPr/>
          </p:nvSpPr>
          <p:spPr>
            <a:xfrm>
              <a:off x="3061440" y="4872240"/>
              <a:ext cx="936720" cy="1208160"/>
            </a:xfrm>
            <a:prstGeom prst="ellipse">
              <a:avLst/>
            </a:prstGeom>
            <a:noFill/>
            <a:ln w="2844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Ellipse 309"/>
            <p:cNvSpPr/>
            <p:nvPr/>
          </p:nvSpPr>
          <p:spPr>
            <a:xfrm>
              <a:off x="3134160" y="4940280"/>
              <a:ext cx="783000" cy="1080000"/>
            </a:xfrm>
            <a:prstGeom prst="ellipse">
              <a:avLst/>
            </a:prstGeom>
            <a:noFill/>
            <a:ln w="2844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89" name="Connecteur droit avec flèche 310"/>
            <p:cNvCxnSpPr/>
            <p:nvPr/>
          </p:nvCxnSpPr>
          <p:spPr>
            <a:xfrm flipH="1" flipV="1">
              <a:off x="2628360" y="5275440"/>
              <a:ext cx="361080" cy="2016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190" name="ZoneTexte 143"/>
            <p:cNvSpPr/>
            <p:nvPr/>
          </p:nvSpPr>
          <p:spPr>
            <a:xfrm>
              <a:off x="3156480" y="5141160"/>
              <a:ext cx="649800" cy="70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RF1, GZM,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NLY,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K,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ASL…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1" name="Ellipse 313"/>
            <p:cNvGrpSpPr/>
            <p:nvPr/>
          </p:nvGrpSpPr>
          <p:grpSpPr>
            <a:xfrm>
              <a:off x="3488400" y="5016960"/>
              <a:ext cx="207720" cy="212400"/>
              <a:chOff x="3488400" y="5016960"/>
              <a:chExt cx="207720" cy="212400"/>
            </a:xfrm>
          </p:grpSpPr>
          <p:pic>
            <p:nvPicPr>
              <p:cNvPr id="192" name="Ellipse 313" descr=""/>
              <p:cNvPicPr/>
              <p:nvPr/>
            </p:nvPicPr>
            <p:blipFill>
              <a:blip r:embed="rId42"/>
              <a:stretch/>
            </p:blipFill>
            <p:spPr>
              <a:xfrm>
                <a:off x="3488400" y="5016960"/>
                <a:ext cx="20772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3" name=""/>
              <p:cNvSpPr/>
              <p:nvPr/>
            </p:nvSpPr>
            <p:spPr>
              <a:xfrm>
                <a:off x="3566520" y="5070240"/>
                <a:ext cx="5832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4" name="Ellipse 315"/>
            <p:cNvGrpSpPr/>
            <p:nvPr/>
          </p:nvGrpSpPr>
          <p:grpSpPr>
            <a:xfrm>
              <a:off x="3294720" y="5742720"/>
              <a:ext cx="207720" cy="212400"/>
              <a:chOff x="3294720" y="5742720"/>
              <a:chExt cx="207720" cy="212400"/>
            </a:xfrm>
          </p:grpSpPr>
          <p:pic>
            <p:nvPicPr>
              <p:cNvPr id="195" name="Ellipse 315" descr=""/>
              <p:cNvPicPr/>
              <p:nvPr/>
            </p:nvPicPr>
            <p:blipFill>
              <a:blip r:embed="rId43"/>
              <a:stretch/>
            </p:blipFill>
            <p:spPr>
              <a:xfrm>
                <a:off x="3294720" y="5742720"/>
                <a:ext cx="20772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6" name=""/>
              <p:cNvSpPr/>
              <p:nvPr/>
            </p:nvSpPr>
            <p:spPr>
              <a:xfrm>
                <a:off x="3371400" y="580032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7" name="Ellipse 316"/>
            <p:cNvGrpSpPr/>
            <p:nvPr/>
          </p:nvGrpSpPr>
          <p:grpSpPr>
            <a:xfrm>
              <a:off x="3427920" y="5834160"/>
              <a:ext cx="208080" cy="212400"/>
              <a:chOff x="3427920" y="5834160"/>
              <a:chExt cx="208080" cy="212400"/>
            </a:xfrm>
          </p:grpSpPr>
          <p:pic>
            <p:nvPicPr>
              <p:cNvPr id="198" name="Ellipse 316" descr=""/>
              <p:cNvPicPr/>
              <p:nvPr/>
            </p:nvPicPr>
            <p:blipFill>
              <a:blip r:embed="rId44"/>
              <a:stretch/>
            </p:blipFill>
            <p:spPr>
              <a:xfrm>
                <a:off x="3427920" y="5834160"/>
                <a:ext cx="20808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9" name=""/>
              <p:cNvSpPr/>
              <p:nvPr/>
            </p:nvSpPr>
            <p:spPr>
              <a:xfrm>
                <a:off x="3506760" y="5891760"/>
                <a:ext cx="5868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0" name="Ellipse 318"/>
            <p:cNvGrpSpPr/>
            <p:nvPr/>
          </p:nvGrpSpPr>
          <p:grpSpPr>
            <a:xfrm>
              <a:off x="3629880" y="5206320"/>
              <a:ext cx="212760" cy="212400"/>
              <a:chOff x="3629880" y="5206320"/>
              <a:chExt cx="212760" cy="212400"/>
            </a:xfrm>
          </p:grpSpPr>
          <p:pic>
            <p:nvPicPr>
              <p:cNvPr id="201" name="Ellipse 318" descr=""/>
              <p:cNvPicPr/>
              <p:nvPr/>
            </p:nvPicPr>
            <p:blipFill>
              <a:blip r:embed="rId45"/>
              <a:stretch/>
            </p:blipFill>
            <p:spPr>
              <a:xfrm>
                <a:off x="3629880" y="520632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2" name=""/>
              <p:cNvSpPr/>
              <p:nvPr/>
            </p:nvSpPr>
            <p:spPr>
              <a:xfrm>
                <a:off x="3710520" y="526428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3" name="Ellipse 319"/>
            <p:cNvGrpSpPr/>
            <p:nvPr/>
          </p:nvGrpSpPr>
          <p:grpSpPr>
            <a:xfrm>
              <a:off x="3599640" y="5705280"/>
              <a:ext cx="208080" cy="212400"/>
              <a:chOff x="3599640" y="5705280"/>
              <a:chExt cx="208080" cy="212400"/>
            </a:xfrm>
          </p:grpSpPr>
          <p:pic>
            <p:nvPicPr>
              <p:cNvPr id="204" name="Ellipse 319" descr=""/>
              <p:cNvPicPr/>
              <p:nvPr/>
            </p:nvPicPr>
            <p:blipFill>
              <a:blip r:embed="rId46"/>
              <a:stretch/>
            </p:blipFill>
            <p:spPr>
              <a:xfrm>
                <a:off x="3599640" y="5705280"/>
                <a:ext cx="20808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5" name=""/>
              <p:cNvSpPr/>
              <p:nvPr/>
            </p:nvSpPr>
            <p:spPr>
              <a:xfrm>
                <a:off x="3676320" y="5759640"/>
                <a:ext cx="5976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6" name="Ellipse 320"/>
            <p:cNvGrpSpPr/>
            <p:nvPr/>
          </p:nvGrpSpPr>
          <p:grpSpPr>
            <a:xfrm>
              <a:off x="3629880" y="5077800"/>
              <a:ext cx="212760" cy="212400"/>
              <a:chOff x="3629880" y="5077800"/>
              <a:chExt cx="212760" cy="212400"/>
            </a:xfrm>
          </p:grpSpPr>
          <p:pic>
            <p:nvPicPr>
              <p:cNvPr id="207" name="Ellipse 320" descr=""/>
              <p:cNvPicPr/>
              <p:nvPr/>
            </p:nvPicPr>
            <p:blipFill>
              <a:blip r:embed="rId47"/>
              <a:stretch/>
            </p:blipFill>
            <p:spPr>
              <a:xfrm>
                <a:off x="3629880" y="507780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8" name=""/>
              <p:cNvSpPr/>
              <p:nvPr/>
            </p:nvSpPr>
            <p:spPr>
              <a:xfrm>
                <a:off x="3710520" y="5135040"/>
                <a:ext cx="5940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9" name="Ellipse 321"/>
            <p:cNvGrpSpPr/>
            <p:nvPr/>
          </p:nvGrpSpPr>
          <p:grpSpPr>
            <a:xfrm>
              <a:off x="3599640" y="5577120"/>
              <a:ext cx="208080" cy="206640"/>
              <a:chOff x="3599640" y="5577120"/>
              <a:chExt cx="208080" cy="206640"/>
            </a:xfrm>
          </p:grpSpPr>
          <p:pic>
            <p:nvPicPr>
              <p:cNvPr id="210" name="Ellipse 321" descr=""/>
              <p:cNvPicPr/>
              <p:nvPr/>
            </p:nvPicPr>
            <p:blipFill>
              <a:blip r:embed="rId48"/>
              <a:stretch/>
            </p:blipFill>
            <p:spPr>
              <a:xfrm>
                <a:off x="3599640" y="5577120"/>
                <a:ext cx="208080" cy="206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1" name=""/>
              <p:cNvSpPr/>
              <p:nvPr/>
            </p:nvSpPr>
            <p:spPr>
              <a:xfrm>
                <a:off x="3676320" y="5630760"/>
                <a:ext cx="5976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2" name="Ellipse 322"/>
            <p:cNvGrpSpPr/>
            <p:nvPr/>
          </p:nvGrpSpPr>
          <p:grpSpPr>
            <a:xfrm>
              <a:off x="3599640" y="5395320"/>
              <a:ext cx="208080" cy="212400"/>
              <a:chOff x="3599640" y="5395320"/>
              <a:chExt cx="208080" cy="212400"/>
            </a:xfrm>
          </p:grpSpPr>
          <p:pic>
            <p:nvPicPr>
              <p:cNvPr id="213" name="Ellipse 322" descr=""/>
              <p:cNvPicPr/>
              <p:nvPr/>
            </p:nvPicPr>
            <p:blipFill>
              <a:blip r:embed="rId49"/>
              <a:stretch/>
            </p:blipFill>
            <p:spPr>
              <a:xfrm>
                <a:off x="3599640" y="5395320"/>
                <a:ext cx="20808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4" name=""/>
              <p:cNvSpPr/>
              <p:nvPr/>
            </p:nvSpPr>
            <p:spPr>
              <a:xfrm>
                <a:off x="3676320" y="5450040"/>
                <a:ext cx="5976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5" name="Ellipse 323"/>
            <p:cNvGrpSpPr/>
            <p:nvPr/>
          </p:nvGrpSpPr>
          <p:grpSpPr>
            <a:xfrm>
              <a:off x="3715560" y="5473800"/>
              <a:ext cx="212760" cy="212400"/>
              <a:chOff x="3715560" y="5473800"/>
              <a:chExt cx="212760" cy="212400"/>
            </a:xfrm>
          </p:grpSpPr>
          <p:pic>
            <p:nvPicPr>
              <p:cNvPr id="216" name="Ellipse 323" descr=""/>
              <p:cNvPicPr/>
              <p:nvPr/>
            </p:nvPicPr>
            <p:blipFill>
              <a:blip r:embed="rId50"/>
              <a:stretch/>
            </p:blipFill>
            <p:spPr>
              <a:xfrm>
                <a:off x="3715560" y="547380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7" name=""/>
              <p:cNvSpPr/>
              <p:nvPr/>
            </p:nvSpPr>
            <p:spPr>
              <a:xfrm>
                <a:off x="3795120" y="5532120"/>
                <a:ext cx="5940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218" name="Connecteur droit avec flèche 330"/>
            <p:cNvCxnSpPr>
              <a:endCxn id="219" idx="1"/>
            </p:cNvCxnSpPr>
            <p:nvPr/>
          </p:nvCxnSpPr>
          <p:spPr>
            <a:xfrm>
              <a:off x="3744720" y="4537080"/>
              <a:ext cx="651240" cy="92484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0" name="Connecteur droit avec flèche 331"/>
            <p:cNvCxnSpPr>
              <a:endCxn id="221" idx="1"/>
            </p:cNvCxnSpPr>
            <p:nvPr/>
          </p:nvCxnSpPr>
          <p:spPr>
            <a:xfrm>
              <a:off x="3782520" y="4538520"/>
              <a:ext cx="516600" cy="4078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221" name="ZoneTexte 160"/>
            <p:cNvSpPr/>
            <p:nvPr/>
          </p:nvSpPr>
          <p:spPr>
            <a:xfrm>
              <a:off x="4298760" y="4838400"/>
              <a:ext cx="431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ZoneTexte 161"/>
            <p:cNvSpPr/>
            <p:nvPr/>
          </p:nvSpPr>
          <p:spPr>
            <a:xfrm>
              <a:off x="4395600" y="5353920"/>
              <a:ext cx="433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P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22" name="Connecteur droit avec flèche 337"/>
            <p:cNvCxnSpPr/>
            <p:nvPr/>
          </p:nvCxnSpPr>
          <p:spPr>
            <a:xfrm>
              <a:off x="4707000" y="4929840"/>
              <a:ext cx="218160" cy="2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3" name="Connecteur droit avec flèche 338"/>
            <p:cNvCxnSpPr/>
            <p:nvPr/>
          </p:nvCxnSpPr>
          <p:spPr>
            <a:xfrm>
              <a:off x="4032720" y="4136400"/>
              <a:ext cx="542520" cy="10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4" name="Connecteur droit avec flèche 339"/>
            <p:cNvCxnSpPr/>
            <p:nvPr/>
          </p:nvCxnSpPr>
          <p:spPr>
            <a:xfrm>
              <a:off x="5223240" y="4136760"/>
              <a:ext cx="216720" cy="2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5" name="Connecteur droit avec flèche 340"/>
            <p:cNvCxnSpPr/>
            <p:nvPr/>
          </p:nvCxnSpPr>
          <p:spPr>
            <a:xfrm>
              <a:off x="6521040" y="4134960"/>
              <a:ext cx="577440" cy="18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6" name="Connecteur droit avec flèche 341"/>
            <p:cNvCxnSpPr/>
            <p:nvPr/>
          </p:nvCxnSpPr>
          <p:spPr>
            <a:xfrm>
              <a:off x="4719600" y="5474880"/>
              <a:ext cx="216720" cy="18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7" name="Connecteur droit avec flèche 342"/>
            <p:cNvCxnSpPr/>
            <p:nvPr/>
          </p:nvCxnSpPr>
          <p:spPr>
            <a:xfrm>
              <a:off x="5728320" y="5474880"/>
              <a:ext cx="216720" cy="18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8" name="Connecteur droit avec flèche 343"/>
            <p:cNvCxnSpPr/>
            <p:nvPr/>
          </p:nvCxnSpPr>
          <p:spPr>
            <a:xfrm>
              <a:off x="6903720" y="5476320"/>
              <a:ext cx="216360" cy="18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29" name="Connecteur droit avec flèche 344"/>
            <p:cNvCxnSpPr/>
            <p:nvPr/>
          </p:nvCxnSpPr>
          <p:spPr>
            <a:xfrm>
              <a:off x="5513760" y="4940280"/>
              <a:ext cx="216720" cy="2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30" name="Connecteur droit avec flèche 345"/>
            <p:cNvCxnSpPr/>
            <p:nvPr/>
          </p:nvCxnSpPr>
          <p:spPr>
            <a:xfrm>
              <a:off x="6425640" y="4940280"/>
              <a:ext cx="216720" cy="2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31" name="Connecteur droit avec flèche 346"/>
            <p:cNvCxnSpPr/>
            <p:nvPr/>
          </p:nvCxnSpPr>
          <p:spPr>
            <a:xfrm>
              <a:off x="7097400" y="4940280"/>
              <a:ext cx="216360" cy="2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pic>
          <p:nvPicPr>
            <p:cNvPr id="232" name="Groupe 184" descr=""/>
            <p:cNvPicPr/>
            <p:nvPr/>
          </p:nvPicPr>
          <p:blipFill>
            <a:blip r:embed="rId51"/>
            <a:stretch/>
          </p:blipFill>
          <p:spPr>
            <a:xfrm>
              <a:off x="7491600" y="4676040"/>
              <a:ext cx="158760" cy="16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3" name="ZoneTexte 350" descr=""/>
            <p:cNvPicPr/>
            <p:nvPr/>
          </p:nvPicPr>
          <p:blipFill>
            <a:blip r:embed="rId52"/>
            <a:stretch/>
          </p:blipFill>
          <p:spPr>
            <a:xfrm>
              <a:off x="8490960" y="3462840"/>
              <a:ext cx="567000" cy="18169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234" name="Connecteur droit avec flèche 352"/>
            <p:cNvCxnSpPr/>
            <p:nvPr/>
          </p:nvCxnSpPr>
          <p:spPr>
            <a:xfrm flipV="1">
              <a:off x="7914240" y="4740120"/>
              <a:ext cx="624960" cy="74484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35" name="Connecteur droit avec flèche 353"/>
            <p:cNvCxnSpPr/>
            <p:nvPr/>
          </p:nvCxnSpPr>
          <p:spPr>
            <a:xfrm>
              <a:off x="7867800" y="4504320"/>
              <a:ext cx="680400" cy="21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36" name="Connecteur droit avec flèche 354"/>
            <p:cNvCxnSpPr/>
            <p:nvPr/>
          </p:nvCxnSpPr>
          <p:spPr>
            <a:xfrm>
              <a:off x="7844040" y="4115880"/>
              <a:ext cx="680400" cy="22932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237" name="Connecteur droit 355"/>
            <p:cNvSpPr/>
            <p:nvPr/>
          </p:nvSpPr>
          <p:spPr>
            <a:xfrm flipH="1">
              <a:off x="2196720" y="1388880"/>
              <a:ext cx="215640" cy="1072440"/>
            </a:xfrm>
            <a:prstGeom prst="line">
              <a:avLst/>
            </a:prstGeom>
            <a:ln w="12600">
              <a:solidFill>
                <a:srgbClr val="bbe0e3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Connecteur droit 361"/>
            <p:cNvSpPr/>
            <p:nvPr/>
          </p:nvSpPr>
          <p:spPr>
            <a:xfrm>
              <a:off x="2485080" y="1388880"/>
              <a:ext cx="572040" cy="1240560"/>
            </a:xfrm>
            <a:prstGeom prst="line">
              <a:avLst/>
            </a:prstGeom>
            <a:ln w="12600">
              <a:solidFill>
                <a:srgbClr val="bbe0e3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9" name="Connecteur droit avec flèche 362"/>
            <p:cNvCxnSpPr/>
            <p:nvPr/>
          </p:nvCxnSpPr>
          <p:spPr>
            <a:xfrm>
              <a:off x="8033400" y="3600360"/>
              <a:ext cx="504000" cy="5086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240" name="Ellipse 363"/>
            <p:cNvGrpSpPr/>
            <p:nvPr/>
          </p:nvGrpSpPr>
          <p:grpSpPr>
            <a:xfrm>
              <a:off x="1048320" y="6253560"/>
              <a:ext cx="865800" cy="298440"/>
              <a:chOff x="1048320" y="6253560"/>
              <a:chExt cx="865800" cy="298440"/>
            </a:xfrm>
          </p:grpSpPr>
          <p:pic>
            <p:nvPicPr>
              <p:cNvPr id="241" name="Ellipse 363" descr=""/>
              <p:cNvPicPr/>
              <p:nvPr/>
            </p:nvPicPr>
            <p:blipFill>
              <a:blip r:embed="rId53"/>
              <a:stretch/>
            </p:blipFill>
            <p:spPr>
              <a:xfrm>
                <a:off x="1048320" y="6253560"/>
                <a:ext cx="865800" cy="298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2" name=""/>
              <p:cNvSpPr/>
              <p:nvPr/>
            </p:nvSpPr>
            <p:spPr>
              <a:xfrm>
                <a:off x="1223280" y="6321240"/>
                <a:ext cx="519840" cy="123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FNs-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3" name="Rectangle à coins arrondis 364"/>
            <p:cNvGrpSpPr/>
            <p:nvPr/>
          </p:nvGrpSpPr>
          <p:grpSpPr>
            <a:xfrm>
              <a:off x="5844240" y="6156000"/>
              <a:ext cx="2001600" cy="395640"/>
              <a:chOff x="5844240" y="6156000"/>
              <a:chExt cx="2001600" cy="395640"/>
            </a:xfrm>
          </p:grpSpPr>
          <p:pic>
            <p:nvPicPr>
              <p:cNvPr id="244" name="Rectangle à coins arrondis 364" descr=""/>
              <p:cNvPicPr/>
              <p:nvPr/>
            </p:nvPicPr>
            <p:blipFill>
              <a:blip r:embed="rId54"/>
              <a:stretch/>
            </p:blipFill>
            <p:spPr>
              <a:xfrm>
                <a:off x="5844240" y="6156000"/>
                <a:ext cx="2001600" cy="395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5" name=""/>
              <p:cNvSpPr/>
              <p:nvPr/>
            </p:nvSpPr>
            <p:spPr>
              <a:xfrm>
                <a:off x="5922720" y="6213960"/>
                <a:ext cx="1847520" cy="242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JAK-STAT signaling pathway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246" name="Connecteur droit avec flèche 365"/>
            <p:cNvCxnSpPr/>
            <p:nvPr/>
          </p:nvCxnSpPr>
          <p:spPr>
            <a:xfrm>
              <a:off x="1969200" y="6346440"/>
              <a:ext cx="3830760" cy="10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47" name="Connecteur droit avec flèche 366"/>
            <p:cNvCxnSpPr/>
            <p:nvPr/>
          </p:nvCxnSpPr>
          <p:spPr>
            <a:xfrm flipV="1">
              <a:off x="7889400" y="5006160"/>
              <a:ext cx="720360" cy="12070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48" name="Connecteur droit avec flèche 367"/>
            <p:cNvCxnSpPr/>
            <p:nvPr/>
          </p:nvCxnSpPr>
          <p:spPr>
            <a:xfrm flipV="1">
              <a:off x="6520680" y="3666600"/>
              <a:ext cx="720360" cy="40824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249" name="ZoneTexte 249"/>
            <p:cNvSpPr/>
            <p:nvPr/>
          </p:nvSpPr>
          <p:spPr>
            <a:xfrm>
              <a:off x="5954040" y="2384640"/>
              <a:ext cx="719280" cy="215640"/>
            </a:xfrm>
            <a:prstGeom prst="rect">
              <a:avLst/>
            </a:prstGeom>
            <a:noFill/>
            <a:ln w="9360">
              <a:solidFill>
                <a:srgbClr val="00b0f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IP(3-5)P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50" name="Connecteur droit avec flèche 370"/>
            <p:cNvCxnSpPr/>
            <p:nvPr/>
          </p:nvCxnSpPr>
          <p:spPr>
            <a:xfrm flipH="1">
              <a:off x="6685920" y="2234160"/>
              <a:ext cx="294120" cy="1317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51" name="Connecteur droit avec flèche 372"/>
            <p:cNvCxnSpPr/>
            <p:nvPr/>
          </p:nvCxnSpPr>
          <p:spPr>
            <a:xfrm flipH="1">
              <a:off x="5438880" y="2591640"/>
              <a:ext cx="506880" cy="2145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252" name="Ellipse 374"/>
            <p:cNvGrpSpPr/>
            <p:nvPr/>
          </p:nvGrpSpPr>
          <p:grpSpPr>
            <a:xfrm>
              <a:off x="4001400" y="1816200"/>
              <a:ext cx="811440" cy="352800"/>
              <a:chOff x="4001400" y="1816200"/>
              <a:chExt cx="811440" cy="352800"/>
            </a:xfrm>
          </p:grpSpPr>
          <p:pic>
            <p:nvPicPr>
              <p:cNvPr id="253" name="Ellipse 374" descr=""/>
              <p:cNvPicPr/>
              <p:nvPr/>
            </p:nvPicPr>
            <p:blipFill>
              <a:blip r:embed="rId55"/>
              <a:stretch/>
            </p:blipFill>
            <p:spPr>
              <a:xfrm>
                <a:off x="4001400" y="1816200"/>
                <a:ext cx="811440" cy="352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4" name=""/>
              <p:cNvSpPr/>
              <p:nvPr/>
            </p:nvSpPr>
            <p:spPr>
              <a:xfrm>
                <a:off x="4169520" y="1891440"/>
                <a:ext cx="48312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LC-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5" name="Connecteur droit 375"/>
            <p:cNvSpPr/>
            <p:nvPr/>
          </p:nvSpPr>
          <p:spPr>
            <a:xfrm>
              <a:off x="2087280" y="2458800"/>
              <a:ext cx="216000" cy="66240"/>
            </a:xfrm>
            <a:prstGeom prst="line">
              <a:avLst/>
            </a:prstGeom>
            <a:ln w="19080">
              <a:solidFill>
                <a:srgbClr val="bbe0e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6" name="Ellipse 376"/>
            <p:cNvGrpSpPr/>
            <p:nvPr/>
          </p:nvGrpSpPr>
          <p:grpSpPr>
            <a:xfrm>
              <a:off x="1104120" y="1731600"/>
              <a:ext cx="835200" cy="341280"/>
              <a:chOff x="1104120" y="1731600"/>
              <a:chExt cx="835200" cy="341280"/>
            </a:xfrm>
          </p:grpSpPr>
          <p:pic>
            <p:nvPicPr>
              <p:cNvPr id="257" name="Ellipse 376" descr=""/>
              <p:cNvPicPr/>
              <p:nvPr/>
            </p:nvPicPr>
            <p:blipFill>
              <a:blip r:embed="rId56"/>
              <a:stretch/>
            </p:blipFill>
            <p:spPr>
              <a:xfrm>
                <a:off x="1104120" y="1731600"/>
                <a:ext cx="835200" cy="341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8" name=""/>
              <p:cNvSpPr/>
              <p:nvPr/>
            </p:nvSpPr>
            <p:spPr>
              <a:xfrm>
                <a:off x="1273320" y="1804320"/>
                <a:ext cx="502920" cy="15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KG2D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259" name="Connecteur droit avec flèche 377"/>
            <p:cNvCxnSpPr/>
            <p:nvPr/>
          </p:nvCxnSpPr>
          <p:spPr>
            <a:xfrm flipV="1">
              <a:off x="1980360" y="1589760"/>
              <a:ext cx="2955240" cy="26784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60" name="Connecteur droit avec flèche 384"/>
            <p:cNvCxnSpPr/>
            <p:nvPr/>
          </p:nvCxnSpPr>
          <p:spPr>
            <a:xfrm flipH="1">
              <a:off x="4790880" y="1668240"/>
              <a:ext cx="367200" cy="18936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61" name="Connecteur droit avec flèche 385"/>
            <p:cNvCxnSpPr/>
            <p:nvPr/>
          </p:nvCxnSpPr>
          <p:spPr>
            <a:xfrm>
              <a:off x="4619520" y="2167200"/>
              <a:ext cx="523440" cy="5616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62" name="Connecteur droit avec flèche 389"/>
            <p:cNvCxnSpPr/>
            <p:nvPr/>
          </p:nvCxnSpPr>
          <p:spPr>
            <a:xfrm>
              <a:off x="5734440" y="1667880"/>
              <a:ext cx="1290600" cy="40212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63" name="Connecteur droit avec flèche 391"/>
            <p:cNvCxnSpPr/>
            <p:nvPr/>
          </p:nvCxnSpPr>
          <p:spPr>
            <a:xfrm>
              <a:off x="5511960" y="5006520"/>
              <a:ext cx="432360" cy="3358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264" name="Connecteur en arc 129"/>
            <p:cNvCxnSpPr/>
            <p:nvPr/>
          </p:nvCxnSpPr>
          <p:spPr>
            <a:xfrm rot="5400000">
              <a:off x="5096520" y="4545720"/>
              <a:ext cx="225000" cy="2423160"/>
            </a:xfrm>
            <a:prstGeom prst="curvedConnector2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265" name="ZoneTexte 319"/>
            <p:cNvSpPr/>
            <p:nvPr/>
          </p:nvSpPr>
          <p:spPr>
            <a:xfrm>
              <a:off x="4721400" y="5845680"/>
              <a:ext cx="144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ovement &amp; exocyto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ZoneTexte 320"/>
            <p:cNvSpPr/>
            <p:nvPr/>
          </p:nvSpPr>
          <p:spPr>
            <a:xfrm>
              <a:off x="108000" y="3801240"/>
              <a:ext cx="1008360" cy="368280"/>
            </a:xfrm>
            <a:prstGeom prst="rect">
              <a:avLst/>
            </a:prstGeom>
            <a:noFill/>
            <a:ln w="9360">
              <a:solidFill>
                <a:srgbClr val="59595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poptosis of targeted cell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7" name="Ellipse 397"/>
            <p:cNvGrpSpPr/>
            <p:nvPr/>
          </p:nvGrpSpPr>
          <p:grpSpPr>
            <a:xfrm>
              <a:off x="811440" y="5138280"/>
              <a:ext cx="212760" cy="212400"/>
              <a:chOff x="811440" y="5138280"/>
              <a:chExt cx="212760" cy="212400"/>
            </a:xfrm>
          </p:grpSpPr>
          <p:pic>
            <p:nvPicPr>
              <p:cNvPr id="268" name="Ellipse 397" descr=""/>
              <p:cNvPicPr/>
              <p:nvPr/>
            </p:nvPicPr>
            <p:blipFill>
              <a:blip r:embed="rId57"/>
              <a:stretch/>
            </p:blipFill>
            <p:spPr>
              <a:xfrm>
                <a:off x="811440" y="513828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9" name=""/>
              <p:cNvSpPr/>
              <p:nvPr/>
            </p:nvSpPr>
            <p:spPr>
              <a:xfrm>
                <a:off x="892080" y="5193360"/>
                <a:ext cx="5940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0" name="Ellipse 398"/>
            <p:cNvGrpSpPr/>
            <p:nvPr/>
          </p:nvGrpSpPr>
          <p:grpSpPr>
            <a:xfrm>
              <a:off x="964080" y="5095440"/>
              <a:ext cx="212760" cy="212400"/>
              <a:chOff x="964080" y="5095440"/>
              <a:chExt cx="212760" cy="212400"/>
            </a:xfrm>
          </p:grpSpPr>
          <p:pic>
            <p:nvPicPr>
              <p:cNvPr id="271" name="Ellipse 398" descr=""/>
              <p:cNvPicPr/>
              <p:nvPr/>
            </p:nvPicPr>
            <p:blipFill>
              <a:blip r:embed="rId58"/>
              <a:stretch/>
            </p:blipFill>
            <p:spPr>
              <a:xfrm>
                <a:off x="964080" y="509544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72" name=""/>
              <p:cNvSpPr/>
              <p:nvPr/>
            </p:nvSpPr>
            <p:spPr>
              <a:xfrm>
                <a:off x="1044720" y="515376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3" name="Ellipse 399"/>
            <p:cNvGrpSpPr/>
            <p:nvPr/>
          </p:nvGrpSpPr>
          <p:grpSpPr>
            <a:xfrm>
              <a:off x="835560" y="5339160"/>
              <a:ext cx="207720" cy="212400"/>
              <a:chOff x="835560" y="5339160"/>
              <a:chExt cx="207720" cy="212400"/>
            </a:xfrm>
          </p:grpSpPr>
          <p:pic>
            <p:nvPicPr>
              <p:cNvPr id="274" name="Ellipse 399" descr=""/>
              <p:cNvPicPr/>
              <p:nvPr/>
            </p:nvPicPr>
            <p:blipFill>
              <a:blip r:embed="rId59"/>
              <a:stretch/>
            </p:blipFill>
            <p:spPr>
              <a:xfrm>
                <a:off x="835560" y="5339160"/>
                <a:ext cx="20772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75" name=""/>
              <p:cNvSpPr/>
              <p:nvPr/>
            </p:nvSpPr>
            <p:spPr>
              <a:xfrm>
                <a:off x="912600" y="5397480"/>
                <a:ext cx="5832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6" name="Ellipse 400"/>
            <p:cNvGrpSpPr/>
            <p:nvPr/>
          </p:nvGrpSpPr>
          <p:grpSpPr>
            <a:xfrm>
              <a:off x="987840" y="5303880"/>
              <a:ext cx="208080" cy="212400"/>
              <a:chOff x="987840" y="5303880"/>
              <a:chExt cx="208080" cy="212400"/>
            </a:xfrm>
          </p:grpSpPr>
          <p:pic>
            <p:nvPicPr>
              <p:cNvPr id="277" name="Ellipse 400" descr=""/>
              <p:cNvPicPr/>
              <p:nvPr/>
            </p:nvPicPr>
            <p:blipFill>
              <a:blip r:embed="rId60"/>
              <a:stretch/>
            </p:blipFill>
            <p:spPr>
              <a:xfrm>
                <a:off x="987840" y="5303880"/>
                <a:ext cx="20808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78" name=""/>
              <p:cNvSpPr/>
              <p:nvPr/>
            </p:nvSpPr>
            <p:spPr>
              <a:xfrm>
                <a:off x="1065240" y="5358600"/>
                <a:ext cx="5868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9" name="Ellipse 401"/>
            <p:cNvGrpSpPr/>
            <p:nvPr/>
          </p:nvGrpSpPr>
          <p:grpSpPr>
            <a:xfrm>
              <a:off x="902160" y="5218200"/>
              <a:ext cx="212760" cy="212400"/>
              <a:chOff x="902160" y="5218200"/>
              <a:chExt cx="212760" cy="212400"/>
            </a:xfrm>
          </p:grpSpPr>
          <p:pic>
            <p:nvPicPr>
              <p:cNvPr id="280" name="Ellipse 401" descr=""/>
              <p:cNvPicPr/>
              <p:nvPr/>
            </p:nvPicPr>
            <p:blipFill>
              <a:blip r:embed="rId61"/>
              <a:stretch/>
            </p:blipFill>
            <p:spPr>
              <a:xfrm>
                <a:off x="902160" y="521820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81" name=""/>
              <p:cNvSpPr/>
              <p:nvPr/>
            </p:nvSpPr>
            <p:spPr>
              <a:xfrm>
                <a:off x="983520" y="527112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2" name="Ellipse 402"/>
            <p:cNvGrpSpPr/>
            <p:nvPr/>
          </p:nvGrpSpPr>
          <p:grpSpPr>
            <a:xfrm>
              <a:off x="1054800" y="5175000"/>
              <a:ext cx="212760" cy="212400"/>
              <a:chOff x="1054800" y="5175000"/>
              <a:chExt cx="212760" cy="212400"/>
            </a:xfrm>
          </p:grpSpPr>
          <p:pic>
            <p:nvPicPr>
              <p:cNvPr id="283" name="Ellipse 402" descr=""/>
              <p:cNvPicPr/>
              <p:nvPr/>
            </p:nvPicPr>
            <p:blipFill>
              <a:blip r:embed="rId62"/>
              <a:stretch/>
            </p:blipFill>
            <p:spPr>
              <a:xfrm>
                <a:off x="1054800" y="517500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84" name=""/>
              <p:cNvSpPr/>
              <p:nvPr/>
            </p:nvSpPr>
            <p:spPr>
              <a:xfrm>
                <a:off x="1136160" y="5232240"/>
                <a:ext cx="5940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85" name="ZoneTexte 330"/>
            <p:cNvSpPr/>
            <p:nvPr/>
          </p:nvSpPr>
          <p:spPr>
            <a:xfrm>
              <a:off x="900360" y="5476680"/>
              <a:ext cx="64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Z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86" name="Ellipse 404"/>
            <p:cNvGrpSpPr/>
            <p:nvPr/>
          </p:nvGrpSpPr>
          <p:grpSpPr>
            <a:xfrm>
              <a:off x="981360" y="4431960"/>
              <a:ext cx="854640" cy="286560"/>
              <a:chOff x="981360" y="4431960"/>
              <a:chExt cx="854640" cy="286560"/>
            </a:xfrm>
          </p:grpSpPr>
          <p:pic>
            <p:nvPicPr>
              <p:cNvPr id="287" name="Ellipse 404" descr=""/>
              <p:cNvPicPr/>
              <p:nvPr/>
            </p:nvPicPr>
            <p:blipFill>
              <a:blip r:embed="rId63"/>
              <a:stretch/>
            </p:blipFill>
            <p:spPr>
              <a:xfrm>
                <a:off x="981360" y="4431960"/>
                <a:ext cx="854640" cy="286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88" name=""/>
              <p:cNvSpPr/>
              <p:nvPr/>
            </p:nvSpPr>
            <p:spPr>
              <a:xfrm>
                <a:off x="1150920" y="4496400"/>
                <a:ext cx="521640" cy="124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ASL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9" name="Ellipse 405"/>
            <p:cNvGrpSpPr/>
            <p:nvPr/>
          </p:nvGrpSpPr>
          <p:grpSpPr>
            <a:xfrm>
              <a:off x="1127880" y="6510960"/>
              <a:ext cx="854280" cy="286200"/>
              <a:chOff x="1127880" y="6510960"/>
              <a:chExt cx="854280" cy="286200"/>
            </a:xfrm>
          </p:grpSpPr>
          <p:pic>
            <p:nvPicPr>
              <p:cNvPr id="290" name="Ellipse 405" descr=""/>
              <p:cNvPicPr/>
              <p:nvPr/>
            </p:nvPicPr>
            <p:blipFill>
              <a:blip r:embed="rId64"/>
              <a:stretch/>
            </p:blipFill>
            <p:spPr>
              <a:xfrm>
                <a:off x="1127880" y="6510960"/>
                <a:ext cx="854280" cy="286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91" name=""/>
              <p:cNvSpPr/>
              <p:nvPr/>
            </p:nvSpPr>
            <p:spPr>
              <a:xfrm>
                <a:off x="1295640" y="6573960"/>
                <a:ext cx="521280" cy="124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RAIL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292" name="Forme 406"/>
            <p:cNvCxnSpPr/>
            <p:nvPr/>
          </p:nvCxnSpPr>
          <p:spPr>
            <a:xfrm flipH="1">
              <a:off x="1816920" y="5141160"/>
              <a:ext cx="7009200" cy="1555920"/>
            </a:xfrm>
            <a:prstGeom prst="curvedConnector5">
              <a:avLst>
                <a:gd name="adj1" fmla="val -2819"/>
                <a:gd name="adj2" fmla="val 53830"/>
                <a:gd name="adj3" fmla="val -2819"/>
              </a:avLst>
            </a:prstGeom>
            <a:ln w="25560">
              <a:solidFill>
                <a:srgbClr val="404040"/>
              </a:solidFill>
              <a:miter/>
              <a:tailEnd len="med" type="arrow" w="med"/>
            </a:ln>
          </p:spPr>
        </p:cxnSp>
        <p:grpSp>
          <p:nvGrpSpPr>
            <p:cNvPr id="293" name="Rectangle à coins arrondis 407"/>
            <p:cNvGrpSpPr/>
            <p:nvPr/>
          </p:nvGrpSpPr>
          <p:grpSpPr>
            <a:xfrm>
              <a:off x="7320240" y="482040"/>
              <a:ext cx="1823400" cy="1048680"/>
              <a:chOff x="7320240" y="482040"/>
              <a:chExt cx="1823400" cy="1048680"/>
            </a:xfrm>
          </p:grpSpPr>
          <p:pic>
            <p:nvPicPr>
              <p:cNvPr id="294" name="Rectangle à coins arrondis 407" descr=""/>
              <p:cNvPicPr/>
              <p:nvPr/>
            </p:nvPicPr>
            <p:blipFill>
              <a:blip r:embed="rId65"/>
              <a:stretch/>
            </p:blipFill>
            <p:spPr>
              <a:xfrm>
                <a:off x="7320240" y="482040"/>
                <a:ext cx="1823400" cy="1048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95" name=""/>
              <p:cNvSpPr/>
              <p:nvPr/>
            </p:nvSpPr>
            <p:spPr>
              <a:xfrm>
                <a:off x="7427880" y="565200"/>
                <a:ext cx="1612800" cy="845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6" name="Rectangle 352"/>
            <p:cNvSpPr/>
            <p:nvPr/>
          </p:nvSpPr>
          <p:spPr>
            <a:xfrm>
              <a:off x="7550280" y="597240"/>
              <a:ext cx="971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nhibitory sign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353"/>
            <p:cNvSpPr/>
            <p:nvPr/>
          </p:nvSpPr>
          <p:spPr>
            <a:xfrm>
              <a:off x="7574400" y="801000"/>
              <a:ext cx="945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ctivator sign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354"/>
            <p:cNvSpPr/>
            <p:nvPr/>
          </p:nvSpPr>
          <p:spPr>
            <a:xfrm>
              <a:off x="7614360" y="1001880"/>
              <a:ext cx="964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p “28 kinases”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355"/>
            <p:cNvSpPr/>
            <p:nvPr/>
          </p:nvSpPr>
          <p:spPr>
            <a:xfrm>
              <a:off x="7416360" y="1201320"/>
              <a:ext cx="1163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p “supervised list”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0" name="Ellipse 413"/>
            <p:cNvGrpSpPr/>
            <p:nvPr/>
          </p:nvGrpSpPr>
          <p:grpSpPr>
            <a:xfrm>
              <a:off x="8436960" y="579600"/>
              <a:ext cx="480960" cy="268560"/>
              <a:chOff x="8436960" y="579600"/>
              <a:chExt cx="480960" cy="268560"/>
            </a:xfrm>
          </p:grpSpPr>
          <p:pic>
            <p:nvPicPr>
              <p:cNvPr id="301" name="Ellipse 413" descr=""/>
              <p:cNvPicPr/>
              <p:nvPr/>
            </p:nvPicPr>
            <p:blipFill>
              <a:blip r:embed="rId66"/>
              <a:stretch/>
            </p:blipFill>
            <p:spPr>
              <a:xfrm>
                <a:off x="8436960" y="579600"/>
                <a:ext cx="480960" cy="268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02" name=""/>
              <p:cNvSpPr/>
              <p:nvPr/>
            </p:nvSpPr>
            <p:spPr>
              <a:xfrm>
                <a:off x="8553600" y="640080"/>
                <a:ext cx="254520" cy="11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3" name="Ellipse 414"/>
            <p:cNvGrpSpPr/>
            <p:nvPr/>
          </p:nvGrpSpPr>
          <p:grpSpPr>
            <a:xfrm>
              <a:off x="8454600" y="798120"/>
              <a:ext cx="475920" cy="268920"/>
              <a:chOff x="8454600" y="798120"/>
              <a:chExt cx="475920" cy="268920"/>
            </a:xfrm>
          </p:grpSpPr>
          <p:pic>
            <p:nvPicPr>
              <p:cNvPr id="304" name="Ellipse 414" descr=""/>
              <p:cNvPicPr/>
              <p:nvPr/>
            </p:nvPicPr>
            <p:blipFill>
              <a:blip r:embed="rId67"/>
              <a:stretch/>
            </p:blipFill>
            <p:spPr>
              <a:xfrm>
                <a:off x="8454600" y="798120"/>
                <a:ext cx="475920" cy="268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05" name=""/>
              <p:cNvSpPr/>
              <p:nvPr/>
            </p:nvSpPr>
            <p:spPr>
              <a:xfrm>
                <a:off x="8567280" y="856440"/>
                <a:ext cx="254880" cy="11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6" name="Ellipse 415"/>
            <p:cNvGrpSpPr/>
            <p:nvPr/>
          </p:nvGrpSpPr>
          <p:grpSpPr>
            <a:xfrm>
              <a:off x="8460720" y="999000"/>
              <a:ext cx="487440" cy="280440"/>
              <a:chOff x="8460720" y="999000"/>
              <a:chExt cx="487440" cy="280440"/>
            </a:xfrm>
          </p:grpSpPr>
          <p:pic>
            <p:nvPicPr>
              <p:cNvPr id="307" name="Ellipse 415" descr=""/>
              <p:cNvPicPr/>
              <p:nvPr/>
            </p:nvPicPr>
            <p:blipFill>
              <a:blip r:embed="rId68"/>
              <a:stretch/>
            </p:blipFill>
            <p:spPr>
              <a:xfrm>
                <a:off x="8460720" y="999000"/>
                <a:ext cx="487440" cy="280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08" name=""/>
              <p:cNvSpPr/>
              <p:nvPr/>
            </p:nvSpPr>
            <p:spPr>
              <a:xfrm>
                <a:off x="8578440" y="1062720"/>
                <a:ext cx="254520" cy="111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9" name="Ellipse 416"/>
            <p:cNvGrpSpPr/>
            <p:nvPr/>
          </p:nvGrpSpPr>
          <p:grpSpPr>
            <a:xfrm>
              <a:off x="8460720" y="1201320"/>
              <a:ext cx="487440" cy="286560"/>
              <a:chOff x="8460720" y="1201320"/>
              <a:chExt cx="487440" cy="286560"/>
            </a:xfrm>
          </p:grpSpPr>
          <p:pic>
            <p:nvPicPr>
              <p:cNvPr id="310" name="Ellipse 416" descr=""/>
              <p:cNvPicPr/>
              <p:nvPr/>
            </p:nvPicPr>
            <p:blipFill>
              <a:blip r:embed="rId69"/>
              <a:stretch/>
            </p:blipFill>
            <p:spPr>
              <a:xfrm>
                <a:off x="8460720" y="1201320"/>
                <a:ext cx="487440" cy="286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11" name=""/>
              <p:cNvSpPr/>
              <p:nvPr/>
            </p:nvSpPr>
            <p:spPr>
              <a:xfrm>
                <a:off x="8581320" y="1269720"/>
                <a:ext cx="253440" cy="112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2" name="Ellipse 417"/>
            <p:cNvGrpSpPr/>
            <p:nvPr/>
          </p:nvGrpSpPr>
          <p:grpSpPr>
            <a:xfrm>
              <a:off x="1000800" y="6066000"/>
              <a:ext cx="865440" cy="298440"/>
              <a:chOff x="1000800" y="6066000"/>
              <a:chExt cx="865440" cy="298440"/>
            </a:xfrm>
          </p:grpSpPr>
          <p:pic>
            <p:nvPicPr>
              <p:cNvPr id="313" name="Ellipse 417" descr=""/>
              <p:cNvPicPr/>
              <p:nvPr/>
            </p:nvPicPr>
            <p:blipFill>
              <a:blip r:embed="rId70"/>
              <a:stretch/>
            </p:blipFill>
            <p:spPr>
              <a:xfrm>
                <a:off x="1000800" y="6066000"/>
                <a:ext cx="865440" cy="298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14" name=""/>
              <p:cNvSpPr/>
              <p:nvPr/>
            </p:nvSpPr>
            <p:spPr>
              <a:xfrm>
                <a:off x="1175760" y="6136200"/>
                <a:ext cx="520920" cy="123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K-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315" name="Connecteur en arc 418"/>
            <p:cNvCxnSpPr>
              <a:endCxn id="266" idx="2"/>
            </p:cNvCxnSpPr>
            <p:nvPr/>
          </p:nvCxnSpPr>
          <p:spPr>
            <a:xfrm flipV="1" rot="16200000">
              <a:off x="130680" y="4650480"/>
              <a:ext cx="1106280" cy="144000"/>
            </a:xfrm>
            <a:prstGeom prst="curvedConnector3">
              <a:avLst>
                <a:gd name="adj1" fmla="val 24674"/>
              </a:avLst>
            </a:prstGeom>
            <a:ln w="25560">
              <a:solidFill>
                <a:srgbClr val="595959"/>
              </a:solidFill>
              <a:miter/>
              <a:tailEnd len="med" type="arrow" w="med"/>
            </a:ln>
          </p:spPr>
        </p:cxnSp>
        <p:grpSp>
          <p:nvGrpSpPr>
            <p:cNvPr id="316" name="Ellipse 419"/>
            <p:cNvGrpSpPr/>
            <p:nvPr/>
          </p:nvGrpSpPr>
          <p:grpSpPr>
            <a:xfrm>
              <a:off x="1890360" y="5206320"/>
              <a:ext cx="212400" cy="212400"/>
              <a:chOff x="1890360" y="5206320"/>
              <a:chExt cx="212400" cy="212400"/>
            </a:xfrm>
          </p:grpSpPr>
          <p:pic>
            <p:nvPicPr>
              <p:cNvPr id="317" name="Ellipse 419" descr=""/>
              <p:cNvPicPr/>
              <p:nvPr/>
            </p:nvPicPr>
            <p:blipFill>
              <a:blip r:embed="rId71"/>
              <a:stretch/>
            </p:blipFill>
            <p:spPr>
              <a:xfrm>
                <a:off x="1890360" y="5206320"/>
                <a:ext cx="21240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18" name=""/>
              <p:cNvSpPr/>
              <p:nvPr/>
            </p:nvSpPr>
            <p:spPr>
              <a:xfrm>
                <a:off x="1971360" y="5261040"/>
                <a:ext cx="5904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9" name="Ellipse 420"/>
            <p:cNvGrpSpPr/>
            <p:nvPr/>
          </p:nvGrpSpPr>
          <p:grpSpPr>
            <a:xfrm>
              <a:off x="2043000" y="5163480"/>
              <a:ext cx="212760" cy="212400"/>
              <a:chOff x="2043000" y="5163480"/>
              <a:chExt cx="212760" cy="212400"/>
            </a:xfrm>
          </p:grpSpPr>
          <p:pic>
            <p:nvPicPr>
              <p:cNvPr id="320" name="Ellipse 420" descr=""/>
              <p:cNvPicPr/>
              <p:nvPr/>
            </p:nvPicPr>
            <p:blipFill>
              <a:blip r:embed="rId72"/>
              <a:stretch/>
            </p:blipFill>
            <p:spPr>
              <a:xfrm>
                <a:off x="2043000" y="516348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21" name=""/>
              <p:cNvSpPr/>
              <p:nvPr/>
            </p:nvSpPr>
            <p:spPr>
              <a:xfrm>
                <a:off x="2124360" y="522108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2" name="Ellipse 421"/>
            <p:cNvGrpSpPr/>
            <p:nvPr/>
          </p:nvGrpSpPr>
          <p:grpSpPr>
            <a:xfrm>
              <a:off x="1915560" y="5407200"/>
              <a:ext cx="212760" cy="212400"/>
              <a:chOff x="1915560" y="5407200"/>
              <a:chExt cx="212760" cy="212400"/>
            </a:xfrm>
          </p:grpSpPr>
          <p:pic>
            <p:nvPicPr>
              <p:cNvPr id="323" name="Ellipse 421" descr=""/>
              <p:cNvPicPr/>
              <p:nvPr/>
            </p:nvPicPr>
            <p:blipFill>
              <a:blip r:embed="rId73"/>
              <a:stretch/>
            </p:blipFill>
            <p:spPr>
              <a:xfrm>
                <a:off x="1915560" y="540720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24" name=""/>
              <p:cNvSpPr/>
              <p:nvPr/>
            </p:nvSpPr>
            <p:spPr>
              <a:xfrm>
                <a:off x="1992960" y="546480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5" name="Ellipse 422"/>
            <p:cNvGrpSpPr/>
            <p:nvPr/>
          </p:nvGrpSpPr>
          <p:grpSpPr>
            <a:xfrm>
              <a:off x="2068200" y="5370120"/>
              <a:ext cx="212760" cy="212400"/>
              <a:chOff x="2068200" y="5370120"/>
              <a:chExt cx="212760" cy="212400"/>
            </a:xfrm>
          </p:grpSpPr>
          <p:pic>
            <p:nvPicPr>
              <p:cNvPr id="326" name="Ellipse 422" descr=""/>
              <p:cNvPicPr/>
              <p:nvPr/>
            </p:nvPicPr>
            <p:blipFill>
              <a:blip r:embed="rId74"/>
              <a:stretch/>
            </p:blipFill>
            <p:spPr>
              <a:xfrm>
                <a:off x="2068200" y="537012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27" name=""/>
              <p:cNvSpPr/>
              <p:nvPr/>
            </p:nvSpPr>
            <p:spPr>
              <a:xfrm>
                <a:off x="2145600" y="542448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8" name="Ellipse 423"/>
            <p:cNvGrpSpPr/>
            <p:nvPr/>
          </p:nvGrpSpPr>
          <p:grpSpPr>
            <a:xfrm>
              <a:off x="1982160" y="5278680"/>
              <a:ext cx="212760" cy="212400"/>
              <a:chOff x="1982160" y="5278680"/>
              <a:chExt cx="212760" cy="212400"/>
            </a:xfrm>
          </p:grpSpPr>
          <p:pic>
            <p:nvPicPr>
              <p:cNvPr id="329" name="Ellipse 423" descr=""/>
              <p:cNvPicPr/>
              <p:nvPr/>
            </p:nvPicPr>
            <p:blipFill>
              <a:blip r:embed="rId75"/>
              <a:stretch/>
            </p:blipFill>
            <p:spPr>
              <a:xfrm>
                <a:off x="1982160" y="527868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30" name=""/>
              <p:cNvSpPr/>
              <p:nvPr/>
            </p:nvSpPr>
            <p:spPr>
              <a:xfrm>
                <a:off x="2063880" y="5337360"/>
                <a:ext cx="59400" cy="6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31" name="Ellipse 424"/>
            <p:cNvGrpSpPr/>
            <p:nvPr/>
          </p:nvGrpSpPr>
          <p:grpSpPr>
            <a:xfrm>
              <a:off x="2135160" y="5241960"/>
              <a:ext cx="212760" cy="212400"/>
              <a:chOff x="2135160" y="5241960"/>
              <a:chExt cx="212760" cy="212400"/>
            </a:xfrm>
          </p:grpSpPr>
          <p:pic>
            <p:nvPicPr>
              <p:cNvPr id="332" name="Ellipse 424" descr=""/>
              <p:cNvPicPr/>
              <p:nvPr/>
            </p:nvPicPr>
            <p:blipFill>
              <a:blip r:embed="rId76"/>
              <a:stretch/>
            </p:blipFill>
            <p:spPr>
              <a:xfrm>
                <a:off x="2135160" y="5241960"/>
                <a:ext cx="212760" cy="21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33" name=""/>
              <p:cNvSpPr/>
              <p:nvPr/>
            </p:nvSpPr>
            <p:spPr>
              <a:xfrm>
                <a:off x="2216880" y="5298480"/>
                <a:ext cx="59400" cy="63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4" name="ZoneTexte 384"/>
            <p:cNvSpPr/>
            <p:nvPr/>
          </p:nvSpPr>
          <p:spPr>
            <a:xfrm>
              <a:off x="1980720" y="5563800"/>
              <a:ext cx="648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ER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Z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35" name="Connecteur en arc 426"/>
            <p:cNvCxnSpPr/>
            <p:nvPr/>
          </p:nvCxnSpPr>
          <p:spPr>
            <a:xfrm flipV="1" rot="16200000">
              <a:off x="-481680" y="5012640"/>
              <a:ext cx="2545920" cy="793080"/>
            </a:xfrm>
            <a:prstGeom prst="curvedConnector5">
              <a:avLst>
                <a:gd name="adj1" fmla="val -1598"/>
                <a:gd name="adj2" fmla="val 50000"/>
                <a:gd name="adj3" fmla="val -1598"/>
              </a:avLst>
            </a:prstGeom>
            <a:ln w="25560">
              <a:solidFill>
                <a:srgbClr val="595959"/>
              </a:solidFill>
              <a:miter/>
              <a:tailEnd len="med" type="arrow" w="med"/>
            </a:ln>
          </p:spPr>
        </p:cxnSp>
        <p:cxnSp>
          <p:nvCxnSpPr>
            <p:cNvPr id="336" name="Connecteur en arc 427"/>
            <p:cNvCxnSpPr/>
            <p:nvPr/>
          </p:nvCxnSpPr>
          <p:spPr>
            <a:xfrm flipV="1" rot="16200000">
              <a:off x="770400" y="4265640"/>
              <a:ext cx="402480" cy="143640"/>
            </a:xfrm>
            <a:prstGeom prst="curvedConnector5">
              <a:avLst>
                <a:gd name="adj1" fmla="val -14234"/>
                <a:gd name="adj2" fmla="val 50000"/>
                <a:gd name="adj3" fmla="val -14234"/>
              </a:avLst>
            </a:prstGeom>
            <a:ln w="25560">
              <a:solidFill>
                <a:srgbClr val="595959"/>
              </a:solidFill>
              <a:miter/>
              <a:tailEnd len="med" type="arrow" w="med"/>
            </a:ln>
          </p:spPr>
        </p:cxnSp>
        <p:grpSp>
          <p:nvGrpSpPr>
            <p:cNvPr id="337" name="Ellipse 428"/>
            <p:cNvGrpSpPr/>
            <p:nvPr/>
          </p:nvGrpSpPr>
          <p:grpSpPr>
            <a:xfrm>
              <a:off x="328680" y="4424760"/>
              <a:ext cx="433440" cy="725040"/>
              <a:chOff x="328680" y="4424760"/>
              <a:chExt cx="433440" cy="725040"/>
            </a:xfrm>
          </p:grpSpPr>
          <p:pic>
            <p:nvPicPr>
              <p:cNvPr id="338" name="Ellipse 428" descr=""/>
              <p:cNvPicPr/>
              <p:nvPr/>
            </p:nvPicPr>
            <p:blipFill>
              <a:blip r:embed="rId77"/>
              <a:stretch/>
            </p:blipFill>
            <p:spPr>
              <a:xfrm>
                <a:off x="328680" y="4424760"/>
                <a:ext cx="433440" cy="725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39" name=""/>
              <p:cNvSpPr/>
              <p:nvPr/>
            </p:nvSpPr>
            <p:spPr>
              <a:xfrm rot="16200000">
                <a:off x="334440" y="4662360"/>
                <a:ext cx="425880" cy="216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AS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0" name="Ellipse 429"/>
            <p:cNvGrpSpPr/>
            <p:nvPr/>
          </p:nvGrpSpPr>
          <p:grpSpPr>
            <a:xfrm>
              <a:off x="579960" y="4438080"/>
              <a:ext cx="414000" cy="682200"/>
              <a:chOff x="579960" y="4438080"/>
              <a:chExt cx="414000" cy="682200"/>
            </a:xfrm>
          </p:grpSpPr>
          <p:pic>
            <p:nvPicPr>
              <p:cNvPr id="341" name="Ellipse 429" descr=""/>
              <p:cNvPicPr/>
              <p:nvPr/>
            </p:nvPicPr>
            <p:blipFill>
              <a:blip r:embed="rId78"/>
              <a:stretch/>
            </p:blipFill>
            <p:spPr>
              <a:xfrm>
                <a:off x="579960" y="4438080"/>
                <a:ext cx="414000" cy="682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42" name=""/>
              <p:cNvSpPr/>
              <p:nvPr/>
            </p:nvSpPr>
            <p:spPr>
              <a:xfrm rot="15921600">
                <a:off x="584640" y="4652280"/>
                <a:ext cx="408240" cy="215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id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3" name="Ellipse 430"/>
            <p:cNvGrpSpPr/>
            <p:nvPr/>
          </p:nvGrpSpPr>
          <p:grpSpPr>
            <a:xfrm>
              <a:off x="1110240" y="2773080"/>
              <a:ext cx="805320" cy="292320"/>
              <a:chOff x="1110240" y="2773080"/>
              <a:chExt cx="805320" cy="292320"/>
            </a:xfrm>
          </p:grpSpPr>
          <p:pic>
            <p:nvPicPr>
              <p:cNvPr id="344" name="Ellipse 430" descr=""/>
              <p:cNvPicPr/>
              <p:nvPr/>
            </p:nvPicPr>
            <p:blipFill>
              <a:blip r:embed="rId79"/>
              <a:stretch/>
            </p:blipFill>
            <p:spPr>
              <a:xfrm>
                <a:off x="1110240" y="2773080"/>
                <a:ext cx="805320" cy="292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45" name=""/>
              <p:cNvSpPr/>
              <p:nvPr/>
            </p:nvSpPr>
            <p:spPr>
              <a:xfrm rot="21437400">
                <a:off x="1274040" y="2845800"/>
                <a:ext cx="485280" cy="111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AK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46" name="Connecteur droit 431"/>
            <p:cNvSpPr/>
            <p:nvPr/>
          </p:nvSpPr>
          <p:spPr>
            <a:xfrm flipH="1">
              <a:off x="2965680" y="2653560"/>
              <a:ext cx="208080" cy="8640"/>
            </a:xfrm>
            <a:prstGeom prst="line">
              <a:avLst/>
            </a:prstGeom>
            <a:ln w="19080">
              <a:solidFill>
                <a:srgbClr val="bbe0e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160" bIns="-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47" name="Connecteur droit avec flèche 432"/>
            <p:cNvCxnSpPr/>
            <p:nvPr/>
          </p:nvCxnSpPr>
          <p:spPr>
            <a:xfrm>
              <a:off x="2411640" y="2863080"/>
              <a:ext cx="289440" cy="3340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348" name="Connecteur droit avec flèche 433"/>
            <p:cNvCxnSpPr/>
            <p:nvPr/>
          </p:nvCxnSpPr>
          <p:spPr>
            <a:xfrm flipV="1">
              <a:off x="2412360" y="2795040"/>
              <a:ext cx="505800" cy="6840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grpSp>
          <p:nvGrpSpPr>
            <p:cNvPr id="349" name="Ellipse 434"/>
            <p:cNvGrpSpPr/>
            <p:nvPr/>
          </p:nvGrpSpPr>
          <p:grpSpPr>
            <a:xfrm>
              <a:off x="1713960" y="2535480"/>
              <a:ext cx="689400" cy="456480"/>
              <a:chOff x="1713960" y="2535480"/>
              <a:chExt cx="689400" cy="456480"/>
            </a:xfrm>
          </p:grpSpPr>
          <p:pic>
            <p:nvPicPr>
              <p:cNvPr id="350" name="Ellipse 434" descr=""/>
              <p:cNvPicPr/>
              <p:nvPr/>
            </p:nvPicPr>
            <p:blipFill>
              <a:blip r:embed="rId80"/>
              <a:stretch/>
            </p:blipFill>
            <p:spPr>
              <a:xfrm>
                <a:off x="1713960" y="2535480"/>
                <a:ext cx="689400" cy="456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51" name=""/>
              <p:cNvSpPr/>
              <p:nvPr/>
            </p:nvSpPr>
            <p:spPr>
              <a:xfrm>
                <a:off x="1865520" y="2626920"/>
                <a:ext cx="394200" cy="236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CK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352" name="Connecteur en arc 435"/>
            <p:cNvCxnSpPr/>
            <p:nvPr/>
          </p:nvCxnSpPr>
          <p:spPr>
            <a:xfrm rot="10800000">
              <a:off x="2340720" y="717480"/>
              <a:ext cx="6413760" cy="3015360"/>
            </a:xfrm>
            <a:prstGeom prst="curvedConnector5">
              <a:avLst>
                <a:gd name="adj1" fmla="val 9357"/>
                <a:gd name="adj2" fmla="val 49994"/>
                <a:gd name="adj3" fmla="val 9357"/>
              </a:avLst>
            </a:prstGeom>
            <a:ln w="12600">
              <a:solidFill>
                <a:srgbClr val="595959"/>
              </a:solidFill>
              <a:prstDash val="sysDash"/>
              <a:miter/>
              <a:tailEnd len="med" type="triangle" w="med"/>
            </a:ln>
          </p:spPr>
        </p:cxnSp>
        <p:grpSp>
          <p:nvGrpSpPr>
            <p:cNvPr id="353" name="Ellipse 436"/>
            <p:cNvGrpSpPr/>
            <p:nvPr/>
          </p:nvGrpSpPr>
          <p:grpSpPr>
            <a:xfrm>
              <a:off x="6308280" y="4358520"/>
              <a:ext cx="706680" cy="322920"/>
              <a:chOff x="6308280" y="4358520"/>
              <a:chExt cx="706680" cy="322920"/>
            </a:xfrm>
          </p:grpSpPr>
          <p:pic>
            <p:nvPicPr>
              <p:cNvPr id="354" name="Ellipse 436" descr=""/>
              <p:cNvPicPr/>
              <p:nvPr/>
            </p:nvPicPr>
            <p:blipFill>
              <a:blip r:embed="rId81"/>
              <a:stretch/>
            </p:blipFill>
            <p:spPr>
              <a:xfrm>
                <a:off x="6308280" y="4358520"/>
                <a:ext cx="706680" cy="322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55" name=""/>
              <p:cNvSpPr/>
              <p:nvPr/>
            </p:nvSpPr>
            <p:spPr>
              <a:xfrm>
                <a:off x="6461280" y="4433400"/>
                <a:ext cx="407160" cy="141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IM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56" name="Ellipse 437"/>
            <p:cNvGrpSpPr/>
            <p:nvPr/>
          </p:nvGrpSpPr>
          <p:grpSpPr>
            <a:xfrm>
              <a:off x="1043640" y="3139560"/>
              <a:ext cx="665640" cy="366120"/>
              <a:chOff x="1043640" y="3139560"/>
              <a:chExt cx="665640" cy="366120"/>
            </a:xfrm>
          </p:grpSpPr>
          <p:pic>
            <p:nvPicPr>
              <p:cNvPr id="357" name="Ellipse 437" descr=""/>
              <p:cNvPicPr/>
              <p:nvPr/>
            </p:nvPicPr>
            <p:blipFill>
              <a:blip r:embed="rId82"/>
              <a:stretch/>
            </p:blipFill>
            <p:spPr>
              <a:xfrm>
                <a:off x="1043640" y="3139560"/>
                <a:ext cx="665640" cy="366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58" name=""/>
              <p:cNvSpPr/>
              <p:nvPr/>
            </p:nvSpPr>
            <p:spPr>
              <a:xfrm rot="243600">
                <a:off x="1187280" y="3218040"/>
                <a:ext cx="385560" cy="17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C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359" name="Connecteur droit avec flèche 438"/>
            <p:cNvCxnSpPr/>
            <p:nvPr/>
          </p:nvCxnSpPr>
          <p:spPr>
            <a:xfrm>
              <a:off x="6975360" y="4505760"/>
              <a:ext cx="216720" cy="10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360" name="ZoneTexte 439"/>
            <p:cNvSpPr/>
            <p:nvPr/>
          </p:nvSpPr>
          <p:spPr>
            <a:xfrm>
              <a:off x="0" y="6013080"/>
              <a:ext cx="1188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ytokine mediated activ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ZoneTexte 440"/>
            <p:cNvSpPr/>
            <p:nvPr/>
          </p:nvSpPr>
          <p:spPr>
            <a:xfrm>
              <a:off x="130320" y="1524960"/>
              <a:ext cx="1089720" cy="50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ti-tumor mediated activatio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ZoneTexte 441"/>
            <p:cNvSpPr/>
            <p:nvPr/>
          </p:nvSpPr>
          <p:spPr>
            <a:xfrm>
              <a:off x="108000" y="2728800"/>
              <a:ext cx="1008360" cy="50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R/NCR or BCR mediated activatio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63" name="Connecteur droit avec flèche 442"/>
            <p:cNvCxnSpPr/>
            <p:nvPr/>
          </p:nvCxnSpPr>
          <p:spPr>
            <a:xfrm flipH="1">
              <a:off x="6183720" y="3133800"/>
              <a:ext cx="35640" cy="23112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cxnSp>
          <p:nvCxnSpPr>
            <p:cNvPr id="364" name="Connecteur droit avec flèche 443"/>
            <p:cNvCxnSpPr/>
            <p:nvPr/>
          </p:nvCxnSpPr>
          <p:spPr>
            <a:xfrm flipH="1">
              <a:off x="6088320" y="3688920"/>
              <a:ext cx="34200" cy="22968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365" name="ZoneTexte 444"/>
            <p:cNvSpPr/>
            <p:nvPr/>
          </p:nvSpPr>
          <p:spPr>
            <a:xfrm>
              <a:off x="1909080" y="2192760"/>
              <a:ext cx="28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262626"/>
                  </a:solidFill>
                  <a:latin typeface="Arial"/>
                  <a:ea typeface="ＭＳ Ｐゴシック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ZoneTexte 455"/>
            <p:cNvSpPr/>
            <p:nvPr/>
          </p:nvSpPr>
          <p:spPr>
            <a:xfrm>
              <a:off x="4287600" y="3331800"/>
              <a:ext cx="28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262626"/>
                  </a:solidFill>
                  <a:latin typeface="Arial"/>
                  <a:ea typeface="ＭＳ Ｐゴシック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ZoneTexte 457"/>
            <p:cNvSpPr/>
            <p:nvPr/>
          </p:nvSpPr>
          <p:spPr>
            <a:xfrm>
              <a:off x="4287600" y="6076440"/>
              <a:ext cx="28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262626"/>
                  </a:solidFill>
                  <a:latin typeface="Arial"/>
                  <a:ea typeface="ＭＳ Ｐゴシック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ZoneTexte 319"/>
            <p:cNvSpPr/>
            <p:nvPr/>
          </p:nvSpPr>
          <p:spPr>
            <a:xfrm>
              <a:off x="7746120" y="4302000"/>
              <a:ext cx="122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 surviv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69" name="Connecteur droit avec flèche 463"/>
            <p:cNvCxnSpPr/>
            <p:nvPr/>
          </p:nvCxnSpPr>
          <p:spPr>
            <a:xfrm flipH="1">
              <a:off x="6354000" y="2393280"/>
              <a:ext cx="748800" cy="1021320"/>
            </a:xfrm>
            <a:prstGeom prst="straightConnector1">
              <a:avLst/>
            </a:prstGeom>
            <a:ln w="25560">
              <a:solidFill>
                <a:srgbClr val="4d4d4d"/>
              </a:solidFill>
              <a:miter/>
              <a:tailEnd len="med" type="arrow" w="med"/>
            </a:ln>
          </p:spPr>
        </p:cxnSp>
        <p:sp>
          <p:nvSpPr>
            <p:cNvPr id="370" name="ZoneTexte 319"/>
            <p:cNvSpPr/>
            <p:nvPr/>
          </p:nvSpPr>
          <p:spPr>
            <a:xfrm rot="2878800">
              <a:off x="7653240" y="3430080"/>
              <a:ext cx="1190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ovement &amp; granules exocyto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ZoneTexte 319"/>
            <p:cNvSpPr/>
            <p:nvPr/>
          </p:nvSpPr>
          <p:spPr>
            <a:xfrm rot="17975400">
              <a:off x="7643880" y="5313960"/>
              <a:ext cx="11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TK regul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72" name="Ellipse 176"/>
            <p:cNvGrpSpPr/>
            <p:nvPr/>
          </p:nvGrpSpPr>
          <p:grpSpPr>
            <a:xfrm>
              <a:off x="3544200" y="4504320"/>
              <a:ext cx="762480" cy="401760"/>
              <a:chOff x="3544200" y="4504320"/>
              <a:chExt cx="762480" cy="401760"/>
            </a:xfrm>
          </p:grpSpPr>
          <p:pic>
            <p:nvPicPr>
              <p:cNvPr id="373" name="Ellipse 176" descr=""/>
              <p:cNvPicPr/>
              <p:nvPr/>
            </p:nvPicPr>
            <p:blipFill>
              <a:blip r:embed="rId83"/>
              <a:stretch/>
            </p:blipFill>
            <p:spPr>
              <a:xfrm>
                <a:off x="3544200" y="4504320"/>
                <a:ext cx="762480" cy="401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74" name=""/>
              <p:cNvSpPr/>
              <p:nvPr/>
            </p:nvSpPr>
            <p:spPr>
              <a:xfrm>
                <a:off x="3705480" y="4585320"/>
                <a:ext cx="449280" cy="200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ASGRP1/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75" name="Text Box 5"/>
          <p:cNvSpPr/>
          <p:nvPr/>
        </p:nvSpPr>
        <p:spPr>
          <a:xfrm>
            <a:off x="0" y="12600"/>
            <a:ext cx="205092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Tahoma"/>
                <a:ea typeface="ＭＳ Ｐゴシック"/>
              </a:rPr>
              <a:t>Figure 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5T12:41:56Z</dcterms:created>
  <dc:creator>sabatierr</dc:creator>
  <dc:description/>
  <dc:language>en-US</dc:language>
  <cp:lastModifiedBy>p067449</cp:lastModifiedBy>
  <dcterms:modified xsi:type="dcterms:W3CDTF">2011-07-19T11:47:11Z</dcterms:modified>
  <cp:revision>5</cp:revision>
  <dc:subject/>
  <dc:title>Diapositive 1</dc:title>
</cp:coreProperties>
</file>